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5"/>
  </p:notesMasterIdLst>
  <p:sldIdLst>
    <p:sldId id="261" r:id="rId2"/>
    <p:sldId id="267" r:id="rId3"/>
    <p:sldId id="263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Yong-Ling Ruan" initials="YR" lastIdx="0" clrIdx="0">
    <p:extLst>
      <p:ext uri="{19B8F6BF-5375-455C-9EA6-DF929625EA0E}">
        <p15:presenceInfo xmlns:p15="http://schemas.microsoft.com/office/powerpoint/2012/main" userId="S-1-5-21-1451058757-1749049392-1947940980-138022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7FF"/>
    <a:srgbClr val="FFCCFF"/>
    <a:srgbClr val="FDE188"/>
    <a:srgbClr val="A4A000"/>
    <a:srgbClr val="B7B315"/>
    <a:srgbClr val="DFDA00"/>
    <a:srgbClr val="F2B800"/>
    <a:srgbClr val="E2B31C"/>
    <a:srgbClr val="E7BE3E"/>
    <a:srgbClr val="B08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540" autoAdjust="0"/>
    <p:restoredTop sz="93814" autoAdjust="0"/>
  </p:normalViewPr>
  <p:slideViewPr>
    <p:cSldViewPr snapToGrid="0" showGuides="1">
      <p:cViewPr>
        <p:scale>
          <a:sx n="75" d="100"/>
          <a:sy n="75" d="100"/>
        </p:scale>
        <p:origin x="1954" y="-2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003;&#24605;&#35797;&#39564;&#25968;&#25454;\2016%20Yongling's%20Lab\qRT-PCR%20Data\si%20shen2017.10.23%20&#65288;2DBA%202DAA%20ovary%20petal%20style%20anther&#65289;\analysi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003;&#24605;&#35797;&#39564;&#25968;&#25454;\2016%20Yongling's%20Lab\qRT-PCR%20Data\si%20shen2017.10.23%20&#65288;2DBA%202DAA%20ovary%20petal%20style%20anther&#65289;\analysi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003;&#24605;&#35797;&#39564;&#25968;&#25454;\2016%20Yongling's%20Lab\qRT-PCR%20Data\si%20shen2017.10.23%20&#65288;2DBA%202DAA%20ovary%20petal%20style%20anther&#65289;\analysi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003;&#24605;&#35797;&#39564;&#25968;&#25454;\2016%20Yongling's%20Lab\qRT-PCR%20Data\si%20shen2017.10.23%20&#65288;2DBA%202DAA%20ovary%20petal%20style%20anther&#65289;\analysi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003;&#24605;&#35797;&#39564;&#25968;&#25454;\2016%20Yongling's%20Lab\qRT-PCR%20Data\si%20shen2017.10.23%20&#65288;2DBA%202DAA%20ovary%20petal%20style%20anther&#65289;\analysis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003;&#24605;&#35797;&#39564;&#25968;&#25454;\2016%20Yongling's%20Lab\qRT-PCR%20Data\si%20shen2017.10.23%20&#65288;2DBA%202DAA%20ovary%20petal%20style%20anther&#65289;\analysis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003;&#24605;&#35797;&#39564;&#25968;&#25454;\2016%20Yongling's%20Lab\qRT-PCR%20Data\si%20shen2017.10.23%20&#65288;2DBA%202DAA%20ovary%20petal%20style%20anther&#65289;\analysis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003;&#24605;&#35797;&#39564;&#25968;&#25454;\2016%20Yongling's%20Lab\qRT-PCR%20Data\si%20shen2017.10.23%20&#65288;2DBA%202DAA%20ovary%20petal%20style%20anther&#65289;\analysis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zh-CN" sz="1200" b="0" i="1" dirty="0">
                <a:solidFill>
                  <a:schemeClr val="tx1">
                    <a:lumMod val="85000"/>
                    <a:lumOff val="15000"/>
                  </a:schemeClr>
                </a:solidFill>
              </a:rPr>
              <a:t>SlHT2</a:t>
            </a:r>
            <a:endParaRPr lang="zh-CN" altLang="en-US" sz="1200" b="0" i="1" dirty="0">
              <a:solidFill>
                <a:schemeClr val="tx1">
                  <a:lumMod val="85000"/>
                  <a:lumOff val="15000"/>
                </a:schemeClr>
              </a:solidFill>
            </a:endParaRPr>
          </a:p>
        </c:rich>
      </c:tx>
      <c:layout>
        <c:manualLayout>
          <c:xMode val="edge"/>
          <c:yMode val="edge"/>
          <c:x val="0.11732777248436764"/>
          <c:y val="0.2460113536140153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Analysis!$BC$70</c:f>
              <c:strCache>
                <c:ptCount val="1"/>
                <c:pt idx="0">
                  <c:v>2DB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nalysis!$BE$71:$BE$74</c:f>
                <c:numCache>
                  <c:formatCode>General</c:formatCode>
                  <c:ptCount val="4"/>
                  <c:pt idx="0">
                    <c:v>3.356057524859726E-3</c:v>
                  </c:pt>
                  <c:pt idx="1">
                    <c:v>2.7495795470723484E-2</c:v>
                  </c:pt>
                  <c:pt idx="2">
                    <c:v>0.1144730183466664</c:v>
                  </c:pt>
                  <c:pt idx="3">
                    <c:v>2.032450733396694E-2</c:v>
                  </c:pt>
                </c:numCache>
              </c:numRef>
            </c:plus>
            <c:minus>
              <c:numRef>
                <c:f>Analysis!$BE$71:$BE$74</c:f>
                <c:numCache>
                  <c:formatCode>General</c:formatCode>
                  <c:ptCount val="4"/>
                  <c:pt idx="0">
                    <c:v>3.356057524859726E-3</c:v>
                  </c:pt>
                  <c:pt idx="1">
                    <c:v>2.7495795470723484E-2</c:v>
                  </c:pt>
                  <c:pt idx="2">
                    <c:v>0.1144730183466664</c:v>
                  </c:pt>
                  <c:pt idx="3">
                    <c:v>2.03245073339669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Analysis!$BB$71:$BB$74</c:f>
              <c:strCache>
                <c:ptCount val="4"/>
                <c:pt idx="0">
                  <c:v>Ovary</c:v>
                </c:pt>
                <c:pt idx="1">
                  <c:v>Style</c:v>
                </c:pt>
                <c:pt idx="2">
                  <c:v>Anther</c:v>
                </c:pt>
                <c:pt idx="3">
                  <c:v>Petal</c:v>
                </c:pt>
              </c:strCache>
            </c:strRef>
          </c:cat>
          <c:val>
            <c:numRef>
              <c:f>Analysis!$BC$71:$BC$74</c:f>
              <c:numCache>
                <c:formatCode>General</c:formatCode>
                <c:ptCount val="4"/>
                <c:pt idx="0">
                  <c:v>4.2434213236295364E-2</c:v>
                </c:pt>
                <c:pt idx="1">
                  <c:v>7.8984521458185922E-2</c:v>
                </c:pt>
                <c:pt idx="2">
                  <c:v>2.2569575759729159</c:v>
                </c:pt>
                <c:pt idx="3">
                  <c:v>0.121553914982311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F88-42F7-A8EB-37CBC5D71E03}"/>
            </c:ext>
          </c:extLst>
        </c:ser>
        <c:ser>
          <c:idx val="1"/>
          <c:order val="1"/>
          <c:tx>
            <c:strRef>
              <c:f>Analysis!$BD$70</c:f>
              <c:strCache>
                <c:ptCount val="1"/>
                <c:pt idx="0">
                  <c:v>4DA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nalysis!$BF$71:$BF$74</c:f>
                <c:numCache>
                  <c:formatCode>General</c:formatCode>
                  <c:ptCount val="4"/>
                  <c:pt idx="0">
                    <c:v>1.1812981647679875E-2</c:v>
                  </c:pt>
                  <c:pt idx="1">
                    <c:v>6.0933055706341895E-2</c:v>
                  </c:pt>
                  <c:pt idx="2">
                    <c:v>0.11223046501453091</c:v>
                  </c:pt>
                  <c:pt idx="3">
                    <c:v>0.3941495768911859</c:v>
                  </c:pt>
                </c:numCache>
              </c:numRef>
            </c:plus>
            <c:minus>
              <c:numRef>
                <c:f>Analysis!$BF$71:$BF$74</c:f>
                <c:numCache>
                  <c:formatCode>General</c:formatCode>
                  <c:ptCount val="4"/>
                  <c:pt idx="0">
                    <c:v>1.1812981647679875E-2</c:v>
                  </c:pt>
                  <c:pt idx="1">
                    <c:v>6.0933055706341895E-2</c:v>
                  </c:pt>
                  <c:pt idx="2">
                    <c:v>0.11223046501453091</c:v>
                  </c:pt>
                  <c:pt idx="3">
                    <c:v>0.394149576891185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nalysis!$BB$71:$BB$74</c:f>
              <c:strCache>
                <c:ptCount val="4"/>
                <c:pt idx="0">
                  <c:v>Ovary</c:v>
                </c:pt>
                <c:pt idx="1">
                  <c:v>Style</c:v>
                </c:pt>
                <c:pt idx="2">
                  <c:v>Anther</c:v>
                </c:pt>
                <c:pt idx="3">
                  <c:v>Petal</c:v>
                </c:pt>
              </c:strCache>
            </c:strRef>
          </c:cat>
          <c:val>
            <c:numRef>
              <c:f>Analysis!$BD$71:$BD$74</c:f>
              <c:numCache>
                <c:formatCode>General</c:formatCode>
                <c:ptCount val="4"/>
                <c:pt idx="0">
                  <c:v>9.4831073358110168E-2</c:v>
                </c:pt>
                <c:pt idx="1">
                  <c:v>0.21681990736245807</c:v>
                </c:pt>
                <c:pt idx="2">
                  <c:v>0.4255750456300989</c:v>
                </c:pt>
                <c:pt idx="3">
                  <c:v>2.59489626468178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F88-42F7-A8EB-37CBC5D71E0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51374904"/>
        <c:axId val="551376872"/>
      </c:barChart>
      <c:catAx>
        <c:axId val="5513749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551376872"/>
        <c:crosses val="autoZero"/>
        <c:auto val="1"/>
        <c:lblAlgn val="ctr"/>
        <c:lblOffset val="100"/>
        <c:noMultiLvlLbl val="0"/>
      </c:catAx>
      <c:valAx>
        <c:axId val="551376872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85000"/>
                    <a:lumOff val="1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551374904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zh-CN" sz="1200" b="0" i="1" dirty="0">
                <a:solidFill>
                  <a:schemeClr val="tx1">
                    <a:lumMod val="85000"/>
                    <a:lumOff val="15000"/>
                  </a:schemeClr>
                </a:solidFill>
              </a:rPr>
              <a:t>SlHT3</a:t>
            </a:r>
            <a:endParaRPr lang="zh-CN" altLang="en-US" sz="1200" b="0" i="1" dirty="0">
              <a:solidFill>
                <a:schemeClr val="tx1">
                  <a:lumMod val="85000"/>
                  <a:lumOff val="15000"/>
                </a:schemeClr>
              </a:solidFill>
            </a:endParaRPr>
          </a:p>
        </c:rich>
      </c:tx>
      <c:layout>
        <c:manualLayout>
          <c:xMode val="edge"/>
          <c:yMode val="edge"/>
          <c:x val="0.11739183874139626"/>
          <c:y val="6.481943589626021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8.6027230338824992E-2"/>
          <c:y val="8.9983605741988909E-2"/>
          <c:w val="0.89186521603978863"/>
          <c:h val="0.70889025209707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Analysis!$BC$80</c:f>
              <c:strCache>
                <c:ptCount val="1"/>
                <c:pt idx="0">
                  <c:v>2DB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nalysis!$BE$81:$BE$84</c:f>
                <c:numCache>
                  <c:formatCode>General</c:formatCode>
                  <c:ptCount val="4"/>
                  <c:pt idx="0">
                    <c:v>6.368783718619761E-2</c:v>
                  </c:pt>
                  <c:pt idx="1">
                    <c:v>0.16601715425812946</c:v>
                  </c:pt>
                  <c:pt idx="2">
                    <c:v>6.567141266323695E-2</c:v>
                  </c:pt>
                  <c:pt idx="3">
                    <c:v>0.13428939632457937</c:v>
                  </c:pt>
                </c:numCache>
              </c:numRef>
            </c:plus>
            <c:minus>
              <c:numRef>
                <c:f>Analysis!$BE$81:$BE$84</c:f>
                <c:numCache>
                  <c:formatCode>General</c:formatCode>
                  <c:ptCount val="4"/>
                  <c:pt idx="0">
                    <c:v>6.368783718619761E-2</c:v>
                  </c:pt>
                  <c:pt idx="1">
                    <c:v>0.16601715425812946</c:v>
                  </c:pt>
                  <c:pt idx="2">
                    <c:v>6.567141266323695E-2</c:v>
                  </c:pt>
                  <c:pt idx="3">
                    <c:v>0.1342893963245793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nalysis!$BB$81:$BB$84</c:f>
              <c:strCache>
                <c:ptCount val="4"/>
                <c:pt idx="0">
                  <c:v>Ovary</c:v>
                </c:pt>
                <c:pt idx="1">
                  <c:v>Style</c:v>
                </c:pt>
                <c:pt idx="2">
                  <c:v>Anther</c:v>
                </c:pt>
                <c:pt idx="3">
                  <c:v>Petal</c:v>
                </c:pt>
              </c:strCache>
            </c:strRef>
          </c:cat>
          <c:val>
            <c:numRef>
              <c:f>Analysis!$BC$81:$BC$84</c:f>
              <c:numCache>
                <c:formatCode>General</c:formatCode>
                <c:ptCount val="4"/>
                <c:pt idx="0">
                  <c:v>0.94085926707271517</c:v>
                </c:pt>
                <c:pt idx="1">
                  <c:v>0.81429846132561134</c:v>
                </c:pt>
                <c:pt idx="2">
                  <c:v>0.93746914043791385</c:v>
                </c:pt>
                <c:pt idx="3">
                  <c:v>0.816366695977675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75B-405E-B5EC-FF385B997573}"/>
            </c:ext>
          </c:extLst>
        </c:ser>
        <c:ser>
          <c:idx val="1"/>
          <c:order val="1"/>
          <c:tx>
            <c:strRef>
              <c:f>Analysis!$BD$80</c:f>
              <c:strCache>
                <c:ptCount val="1"/>
                <c:pt idx="0">
                  <c:v>4DA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nalysis!$BF$81:$BF$84</c:f>
                <c:numCache>
                  <c:formatCode>General</c:formatCode>
                  <c:ptCount val="4"/>
                  <c:pt idx="0">
                    <c:v>7.8783931088750439E-2</c:v>
                  </c:pt>
                  <c:pt idx="1">
                    <c:v>0.11589249768800301</c:v>
                  </c:pt>
                  <c:pt idx="2">
                    <c:v>0.46749803365195941</c:v>
                  </c:pt>
                  <c:pt idx="3">
                    <c:v>0.30651431000715479</c:v>
                  </c:pt>
                </c:numCache>
              </c:numRef>
            </c:plus>
            <c:minus>
              <c:numRef>
                <c:f>Analysis!$BF$81:$BF$84</c:f>
                <c:numCache>
                  <c:formatCode>General</c:formatCode>
                  <c:ptCount val="4"/>
                  <c:pt idx="0">
                    <c:v>7.8783931088750439E-2</c:v>
                  </c:pt>
                  <c:pt idx="1">
                    <c:v>0.11589249768800301</c:v>
                  </c:pt>
                  <c:pt idx="2">
                    <c:v>0.46749803365195941</c:v>
                  </c:pt>
                  <c:pt idx="3">
                    <c:v>0.3065143100071547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nalysis!$BB$81:$BB$84</c:f>
              <c:strCache>
                <c:ptCount val="4"/>
                <c:pt idx="0">
                  <c:v>Ovary</c:v>
                </c:pt>
                <c:pt idx="1">
                  <c:v>Style</c:v>
                </c:pt>
                <c:pt idx="2">
                  <c:v>Anther</c:v>
                </c:pt>
                <c:pt idx="3">
                  <c:v>Petal</c:v>
                </c:pt>
              </c:strCache>
            </c:strRef>
          </c:cat>
          <c:val>
            <c:numRef>
              <c:f>Analysis!$BD$81:$BD$84</c:f>
              <c:numCache>
                <c:formatCode>General</c:formatCode>
                <c:ptCount val="4"/>
                <c:pt idx="0">
                  <c:v>1.0272132950246391</c:v>
                </c:pt>
                <c:pt idx="1">
                  <c:v>0.94142523646779874</c:v>
                </c:pt>
                <c:pt idx="2">
                  <c:v>2.728745746168928</c:v>
                </c:pt>
                <c:pt idx="3">
                  <c:v>1.69892975282389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75B-405E-B5EC-FF385B99757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54227576"/>
        <c:axId val="654224952"/>
      </c:barChart>
      <c:catAx>
        <c:axId val="6542275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85000"/>
                    <a:lumOff val="1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54224952"/>
        <c:crosses val="autoZero"/>
        <c:auto val="1"/>
        <c:lblAlgn val="ctr"/>
        <c:lblOffset val="100"/>
        <c:noMultiLvlLbl val="0"/>
      </c:catAx>
      <c:valAx>
        <c:axId val="654224952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>
                <a:lumMod val="95000"/>
                <a:lumOff val="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85000"/>
                    <a:lumOff val="1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54227576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zh-CN" sz="1200" b="0" i="1" dirty="0">
                <a:solidFill>
                  <a:schemeClr val="tx1">
                    <a:lumMod val="85000"/>
                    <a:lumOff val="15000"/>
                  </a:schemeClr>
                </a:solidFill>
              </a:rPr>
              <a:t>SlHT1</a:t>
            </a:r>
            <a:endParaRPr lang="zh-CN" altLang="en-US" sz="1200" b="0" i="1" dirty="0">
              <a:solidFill>
                <a:schemeClr val="tx1">
                  <a:lumMod val="85000"/>
                  <a:lumOff val="15000"/>
                </a:schemeClr>
              </a:solidFill>
            </a:endParaRPr>
          </a:p>
        </c:rich>
      </c:tx>
      <c:layout>
        <c:manualLayout>
          <c:xMode val="edge"/>
          <c:yMode val="edge"/>
          <c:x val="0.14447079297051452"/>
          <c:y val="0.2130248463251143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9.7734523614696561E-2"/>
          <c:y val="0.2380536887906668"/>
          <c:w val="0.85679346694376546"/>
          <c:h val="0.6446722996681418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Analysis!$BC$58</c:f>
              <c:strCache>
                <c:ptCount val="1"/>
                <c:pt idx="0">
                  <c:v>2DB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nalysis!$BE$59:$BE$62</c:f>
                <c:numCache>
                  <c:formatCode>General</c:formatCode>
                  <c:ptCount val="4"/>
                  <c:pt idx="0">
                    <c:v>7.1083960180586395E-2</c:v>
                  </c:pt>
                  <c:pt idx="1">
                    <c:v>0.22424322059324286</c:v>
                  </c:pt>
                  <c:pt idx="2">
                    <c:v>2.4009708256902264E-2</c:v>
                  </c:pt>
                  <c:pt idx="3">
                    <c:v>0.36857497262419958</c:v>
                  </c:pt>
                </c:numCache>
              </c:numRef>
            </c:plus>
            <c:minus>
              <c:numRef>
                <c:f>Analysis!$BE$59:$BE$62</c:f>
                <c:numCache>
                  <c:formatCode>General</c:formatCode>
                  <c:ptCount val="4"/>
                  <c:pt idx="0">
                    <c:v>7.1083960180586395E-2</c:v>
                  </c:pt>
                  <c:pt idx="1">
                    <c:v>0.22424322059324286</c:v>
                  </c:pt>
                  <c:pt idx="2">
                    <c:v>2.4009708256902264E-2</c:v>
                  </c:pt>
                  <c:pt idx="3">
                    <c:v>0.3685749726241995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nalysis!$BB$59:$BB$62</c:f>
              <c:strCache>
                <c:ptCount val="4"/>
                <c:pt idx="0">
                  <c:v>Ovary</c:v>
                </c:pt>
                <c:pt idx="1">
                  <c:v>Style</c:v>
                </c:pt>
                <c:pt idx="2">
                  <c:v>Anther</c:v>
                </c:pt>
                <c:pt idx="3">
                  <c:v>Petal</c:v>
                </c:pt>
              </c:strCache>
            </c:strRef>
          </c:cat>
          <c:val>
            <c:numRef>
              <c:f>Analysis!$BC$59:$BC$62</c:f>
              <c:numCache>
                <c:formatCode>General</c:formatCode>
                <c:ptCount val="4"/>
                <c:pt idx="0">
                  <c:v>0.75254097116075547</c:v>
                </c:pt>
                <c:pt idx="1">
                  <c:v>1.8850018760361107</c:v>
                </c:pt>
                <c:pt idx="2">
                  <c:v>0.33963392596525782</c:v>
                </c:pt>
                <c:pt idx="3">
                  <c:v>2.63395970490175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20E-4D23-870A-8922C2374C24}"/>
            </c:ext>
          </c:extLst>
        </c:ser>
        <c:ser>
          <c:idx val="1"/>
          <c:order val="1"/>
          <c:tx>
            <c:strRef>
              <c:f>Analysis!$BD$58</c:f>
              <c:strCache>
                <c:ptCount val="1"/>
                <c:pt idx="0">
                  <c:v>4DA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nalysis!$BF$59:$BF$62</c:f>
                <c:numCache>
                  <c:formatCode>General</c:formatCode>
                  <c:ptCount val="4"/>
                  <c:pt idx="0">
                    <c:v>6.2942370428951372E-2</c:v>
                  </c:pt>
                  <c:pt idx="1">
                    <c:v>0.26154133891847625</c:v>
                  </c:pt>
                  <c:pt idx="2">
                    <c:v>0.5802070961983411</c:v>
                  </c:pt>
                  <c:pt idx="3">
                    <c:v>0.27335672116996518</c:v>
                  </c:pt>
                </c:numCache>
              </c:numRef>
            </c:plus>
            <c:minus>
              <c:numRef>
                <c:f>Analysis!$BF$59:$BF$62</c:f>
                <c:numCache>
                  <c:formatCode>General</c:formatCode>
                  <c:ptCount val="4"/>
                  <c:pt idx="0">
                    <c:v>6.2942370428951372E-2</c:v>
                  </c:pt>
                  <c:pt idx="1">
                    <c:v>0.26154133891847625</c:v>
                  </c:pt>
                  <c:pt idx="2">
                    <c:v>0.5802070961983411</c:v>
                  </c:pt>
                  <c:pt idx="3">
                    <c:v>0.2733567211699651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nalysis!$BB$59:$BB$62</c:f>
              <c:strCache>
                <c:ptCount val="4"/>
                <c:pt idx="0">
                  <c:v>Ovary</c:v>
                </c:pt>
                <c:pt idx="1">
                  <c:v>Style</c:v>
                </c:pt>
                <c:pt idx="2">
                  <c:v>Anther</c:v>
                </c:pt>
                <c:pt idx="3">
                  <c:v>Petal</c:v>
                </c:pt>
              </c:strCache>
            </c:strRef>
          </c:cat>
          <c:val>
            <c:numRef>
              <c:f>Analysis!$BD$59:$BD$62</c:f>
              <c:numCache>
                <c:formatCode>General</c:formatCode>
                <c:ptCount val="4"/>
                <c:pt idx="0">
                  <c:v>0.59915583689619256</c:v>
                </c:pt>
                <c:pt idx="1">
                  <c:v>1.6640605131901349</c:v>
                </c:pt>
                <c:pt idx="2">
                  <c:v>2.5324946894713429</c:v>
                </c:pt>
                <c:pt idx="3">
                  <c:v>3.99773620310327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20E-4D23-870A-8922C2374C2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60664624"/>
        <c:axId val="660663968"/>
      </c:barChart>
      <c:catAx>
        <c:axId val="6606646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60663968"/>
        <c:crosses val="autoZero"/>
        <c:auto val="1"/>
        <c:lblAlgn val="ctr"/>
        <c:lblOffset val="100"/>
        <c:noMultiLvlLbl val="0"/>
      </c:catAx>
      <c:valAx>
        <c:axId val="660663968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85000"/>
                    <a:lumOff val="1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60664624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12259408186651974"/>
          <c:y val="0.35896471344588693"/>
          <c:w val="0.17022911515342803"/>
          <c:h val="0.1903393579939119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176320346865622"/>
          <c:y val="5.6825680270723392E-2"/>
          <c:w val="0.88978750537538742"/>
          <c:h val="0.9038293841868236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Analysis!$BC$3</c:f>
              <c:strCache>
                <c:ptCount val="1"/>
                <c:pt idx="0">
                  <c:v>2DB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nalysis!$BE$4:$BE$7</c:f>
                <c:numCache>
                  <c:formatCode>General</c:formatCode>
                  <c:ptCount val="4"/>
                  <c:pt idx="0">
                    <c:v>1.8038698899129548E-3</c:v>
                  </c:pt>
                  <c:pt idx="1">
                    <c:v>7.1893046543214179E-3</c:v>
                  </c:pt>
                  <c:pt idx="2">
                    <c:v>0.18533629352648565</c:v>
                  </c:pt>
                  <c:pt idx="3">
                    <c:v>3.5137954872796334E-3</c:v>
                  </c:pt>
                </c:numCache>
              </c:numRef>
            </c:plus>
            <c:minus>
              <c:numRef>
                <c:f>Analysis!$BE$4:$BE$7</c:f>
                <c:numCache>
                  <c:formatCode>General</c:formatCode>
                  <c:ptCount val="4"/>
                  <c:pt idx="0">
                    <c:v>1.8038698899129548E-3</c:v>
                  </c:pt>
                  <c:pt idx="1">
                    <c:v>7.1893046543214179E-3</c:v>
                  </c:pt>
                  <c:pt idx="2">
                    <c:v>0.18533629352648565</c:v>
                  </c:pt>
                  <c:pt idx="3">
                    <c:v>3.5137954872796334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nalysis!$BB$4:$BB$7</c:f>
              <c:strCache>
                <c:ptCount val="4"/>
                <c:pt idx="0">
                  <c:v>Ovary</c:v>
                </c:pt>
                <c:pt idx="1">
                  <c:v>Style</c:v>
                </c:pt>
                <c:pt idx="2">
                  <c:v>Anther</c:v>
                </c:pt>
                <c:pt idx="3">
                  <c:v>Petal</c:v>
                </c:pt>
              </c:strCache>
            </c:strRef>
          </c:cat>
          <c:val>
            <c:numRef>
              <c:f>Analysis!$BC$4:$BC$7</c:f>
              <c:numCache>
                <c:formatCode>General</c:formatCode>
                <c:ptCount val="4"/>
                <c:pt idx="0">
                  <c:v>1.031763947318478E-2</c:v>
                </c:pt>
                <c:pt idx="1">
                  <c:v>4.7267305175882297E-2</c:v>
                </c:pt>
                <c:pt idx="2">
                  <c:v>2.3048183442763532</c:v>
                </c:pt>
                <c:pt idx="3">
                  <c:v>1.83931597246828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F48-4319-936E-733216BE4801}"/>
            </c:ext>
          </c:extLst>
        </c:ser>
        <c:ser>
          <c:idx val="1"/>
          <c:order val="1"/>
          <c:tx>
            <c:strRef>
              <c:f>Analysis!$BD$3</c:f>
              <c:strCache>
                <c:ptCount val="1"/>
                <c:pt idx="0">
                  <c:v>4DA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nalysis!$BF$4:$BF$7</c:f>
                <c:numCache>
                  <c:formatCode>General</c:formatCode>
                  <c:ptCount val="4"/>
                  <c:pt idx="0">
                    <c:v>9.8716844791332738E-4</c:v>
                  </c:pt>
                  <c:pt idx="1">
                    <c:v>6.6471545730594231E-2</c:v>
                  </c:pt>
                  <c:pt idx="2">
                    <c:v>0.34474100578080552</c:v>
                  </c:pt>
                  <c:pt idx="3">
                    <c:v>7.2432108038931898E-3</c:v>
                  </c:pt>
                </c:numCache>
              </c:numRef>
            </c:plus>
            <c:minus>
              <c:numRef>
                <c:f>Analysis!$BF$4:$BF$7</c:f>
                <c:numCache>
                  <c:formatCode>General</c:formatCode>
                  <c:ptCount val="4"/>
                  <c:pt idx="0">
                    <c:v>9.8716844791332738E-4</c:v>
                  </c:pt>
                  <c:pt idx="1">
                    <c:v>6.6471545730594231E-2</c:v>
                  </c:pt>
                  <c:pt idx="2">
                    <c:v>0.34474100578080552</c:v>
                  </c:pt>
                  <c:pt idx="3">
                    <c:v>7.2432108038931898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nalysis!$BB$4:$BB$7</c:f>
              <c:strCache>
                <c:ptCount val="4"/>
                <c:pt idx="0">
                  <c:v>Ovary</c:v>
                </c:pt>
                <c:pt idx="1">
                  <c:v>Style</c:v>
                </c:pt>
                <c:pt idx="2">
                  <c:v>Anther</c:v>
                </c:pt>
                <c:pt idx="3">
                  <c:v>Petal</c:v>
                </c:pt>
              </c:strCache>
            </c:strRef>
          </c:cat>
          <c:val>
            <c:numRef>
              <c:f>Analysis!$BD$4:$BD$7</c:f>
              <c:numCache>
                <c:formatCode>General</c:formatCode>
                <c:ptCount val="4"/>
                <c:pt idx="0">
                  <c:v>7.2688903088255824E-3</c:v>
                </c:pt>
                <c:pt idx="1">
                  <c:v>0.4260022001656058</c:v>
                </c:pt>
                <c:pt idx="2">
                  <c:v>3.227314892937585</c:v>
                </c:pt>
                <c:pt idx="3">
                  <c:v>4.060099451033781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F48-4319-936E-733216BE48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54244920"/>
        <c:axId val="554245576"/>
      </c:barChart>
      <c:catAx>
        <c:axId val="554244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554245576"/>
        <c:crosses val="autoZero"/>
        <c:auto val="1"/>
        <c:lblAlgn val="ctr"/>
        <c:lblOffset val="100"/>
        <c:noMultiLvlLbl val="0"/>
      </c:catAx>
      <c:valAx>
        <c:axId val="55424557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5542449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10624946081494123"/>
          <c:y val="9.0334542812127813E-2"/>
          <c:w val="0.21162648158547853"/>
          <c:h val="0.3413719953793239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2929031438738055E-2"/>
          <c:y val="4.8440972222222226E-2"/>
          <c:w val="0.86442364755789902"/>
          <c:h val="0.8660777777777779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Analysis!$BC$14</c:f>
              <c:strCache>
                <c:ptCount val="1"/>
                <c:pt idx="0">
                  <c:v>2DB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nalysis!$BE$15:$BE$18</c:f>
                <c:numCache>
                  <c:formatCode>General</c:formatCode>
                  <c:ptCount val="4"/>
                  <c:pt idx="0">
                    <c:v>0.64993178740870139</c:v>
                  </c:pt>
                  <c:pt idx="1">
                    <c:v>5.8216555212503712E-2</c:v>
                  </c:pt>
                  <c:pt idx="2">
                    <c:v>1.4158224720430455E-2</c:v>
                  </c:pt>
                  <c:pt idx="3">
                    <c:v>5.1880563053177356E-2</c:v>
                  </c:pt>
                </c:numCache>
              </c:numRef>
            </c:plus>
            <c:minus>
              <c:numRef>
                <c:f>Analysis!$BE$15:$BE$18</c:f>
                <c:numCache>
                  <c:formatCode>General</c:formatCode>
                  <c:ptCount val="4"/>
                  <c:pt idx="0">
                    <c:v>0.64993178740870139</c:v>
                  </c:pt>
                  <c:pt idx="1">
                    <c:v>5.8216555212503712E-2</c:v>
                  </c:pt>
                  <c:pt idx="2">
                    <c:v>1.4158224720430455E-2</c:v>
                  </c:pt>
                  <c:pt idx="3">
                    <c:v>5.188056305317735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nalysis!$BB$15:$BB$18</c:f>
              <c:strCache>
                <c:ptCount val="4"/>
                <c:pt idx="0">
                  <c:v>Ovary</c:v>
                </c:pt>
                <c:pt idx="1">
                  <c:v>Style</c:v>
                </c:pt>
                <c:pt idx="2">
                  <c:v>Anther</c:v>
                </c:pt>
                <c:pt idx="3">
                  <c:v>Petal</c:v>
                </c:pt>
              </c:strCache>
            </c:strRef>
          </c:cat>
          <c:val>
            <c:numRef>
              <c:f>Analysis!$BC$15:$BC$18</c:f>
              <c:numCache>
                <c:formatCode>General</c:formatCode>
                <c:ptCount val="4"/>
                <c:pt idx="0">
                  <c:v>4.3436857083353235</c:v>
                </c:pt>
                <c:pt idx="1">
                  <c:v>0.27503004917894125</c:v>
                </c:pt>
                <c:pt idx="2">
                  <c:v>0.1517899235826205</c:v>
                </c:pt>
                <c:pt idx="3">
                  <c:v>0.168673857743474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0B0-494A-9E92-F2EA876CCF87}"/>
            </c:ext>
          </c:extLst>
        </c:ser>
        <c:ser>
          <c:idx val="1"/>
          <c:order val="1"/>
          <c:tx>
            <c:strRef>
              <c:f>Analysis!$BD$14</c:f>
              <c:strCache>
                <c:ptCount val="1"/>
                <c:pt idx="0">
                  <c:v>4DA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nalysis!$BF$15:$BF$18</c:f>
                <c:numCache>
                  <c:formatCode>General</c:formatCode>
                  <c:ptCount val="4"/>
                  <c:pt idx="0">
                    <c:v>0.35431348753020941</c:v>
                  </c:pt>
                  <c:pt idx="1">
                    <c:v>5.1382568126169974E-2</c:v>
                  </c:pt>
                  <c:pt idx="2">
                    <c:v>0.3292383777687049</c:v>
                  </c:pt>
                  <c:pt idx="3">
                    <c:v>1.0673673823886014</c:v>
                  </c:pt>
                </c:numCache>
              </c:numRef>
            </c:plus>
            <c:minus>
              <c:numRef>
                <c:f>Analysis!$BF$15:$BF$18</c:f>
                <c:numCache>
                  <c:formatCode>General</c:formatCode>
                  <c:ptCount val="4"/>
                  <c:pt idx="0">
                    <c:v>0.35431348753020941</c:v>
                  </c:pt>
                  <c:pt idx="1">
                    <c:v>5.1382568126169974E-2</c:v>
                  </c:pt>
                  <c:pt idx="2">
                    <c:v>0.3292383777687049</c:v>
                  </c:pt>
                  <c:pt idx="3">
                    <c:v>1.067367382388601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nalysis!$BB$15:$BB$18</c:f>
              <c:strCache>
                <c:ptCount val="4"/>
                <c:pt idx="0">
                  <c:v>Ovary</c:v>
                </c:pt>
                <c:pt idx="1">
                  <c:v>Style</c:v>
                </c:pt>
                <c:pt idx="2">
                  <c:v>Anther</c:v>
                </c:pt>
                <c:pt idx="3">
                  <c:v>Petal</c:v>
                </c:pt>
              </c:strCache>
            </c:strRef>
          </c:cat>
          <c:val>
            <c:numRef>
              <c:f>Analysis!$BD$15:$BD$18</c:f>
              <c:numCache>
                <c:formatCode>General</c:formatCode>
                <c:ptCount val="4"/>
                <c:pt idx="0">
                  <c:v>2.0708700466289964</c:v>
                </c:pt>
                <c:pt idx="1">
                  <c:v>0.26330969025669049</c:v>
                </c:pt>
                <c:pt idx="2">
                  <c:v>1.8312575196113776</c:v>
                </c:pt>
                <c:pt idx="3">
                  <c:v>4.67914870975088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0B0-494A-9E92-F2EA876CCF8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43539304"/>
        <c:axId val="543540944"/>
      </c:barChart>
      <c:catAx>
        <c:axId val="5435393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543540944"/>
        <c:crosses val="autoZero"/>
        <c:auto val="1"/>
        <c:lblAlgn val="ctr"/>
        <c:lblOffset val="100"/>
        <c:noMultiLvlLbl val="0"/>
      </c:catAx>
      <c:valAx>
        <c:axId val="54354094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5435393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3601836266749687E-2"/>
          <c:y val="4.8440972222222226E-2"/>
          <c:w val="0.87056047762923816"/>
          <c:h val="0.8413819444444444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Analysis!$BC$24</c:f>
              <c:strCache>
                <c:ptCount val="1"/>
                <c:pt idx="0">
                  <c:v>2DB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nalysis!$BE$25:$BE$28</c:f>
                <c:numCache>
                  <c:formatCode>General</c:formatCode>
                  <c:ptCount val="4"/>
                  <c:pt idx="0">
                    <c:v>0.42893778559561629</c:v>
                  </c:pt>
                  <c:pt idx="1">
                    <c:v>0.10963870795403161</c:v>
                  </c:pt>
                  <c:pt idx="2">
                    <c:v>2.1602522924726638E-2</c:v>
                  </c:pt>
                  <c:pt idx="3">
                    <c:v>0.4972901661820659</c:v>
                  </c:pt>
                </c:numCache>
              </c:numRef>
            </c:plus>
            <c:minus>
              <c:numRef>
                <c:f>Analysis!$BE$25:$BE$28</c:f>
                <c:numCache>
                  <c:formatCode>General</c:formatCode>
                  <c:ptCount val="4"/>
                  <c:pt idx="0">
                    <c:v>0.42893778559561629</c:v>
                  </c:pt>
                  <c:pt idx="1">
                    <c:v>0.10963870795403161</c:v>
                  </c:pt>
                  <c:pt idx="2">
                    <c:v>2.1602522924726638E-2</c:v>
                  </c:pt>
                  <c:pt idx="3">
                    <c:v>0.497290166182065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nalysis!$BB$25:$BB$28</c:f>
              <c:strCache>
                <c:ptCount val="4"/>
                <c:pt idx="0">
                  <c:v>Ovary</c:v>
                </c:pt>
                <c:pt idx="1">
                  <c:v>Style</c:v>
                </c:pt>
                <c:pt idx="2">
                  <c:v>Anther</c:v>
                </c:pt>
                <c:pt idx="3">
                  <c:v>Petal</c:v>
                </c:pt>
              </c:strCache>
            </c:strRef>
          </c:cat>
          <c:val>
            <c:numRef>
              <c:f>Analysis!$BC$25:$BC$28</c:f>
              <c:numCache>
                <c:formatCode>General</c:formatCode>
                <c:ptCount val="4"/>
                <c:pt idx="0">
                  <c:v>2.3903333606660553</c:v>
                </c:pt>
                <c:pt idx="1">
                  <c:v>0.31604947946964085</c:v>
                </c:pt>
                <c:pt idx="2">
                  <c:v>0.22191657030975609</c:v>
                </c:pt>
                <c:pt idx="3">
                  <c:v>1.90554393236768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7A5-4743-B6A3-14806F55DB88}"/>
            </c:ext>
          </c:extLst>
        </c:ser>
        <c:ser>
          <c:idx val="1"/>
          <c:order val="1"/>
          <c:tx>
            <c:strRef>
              <c:f>Analysis!$BD$24</c:f>
              <c:strCache>
                <c:ptCount val="1"/>
                <c:pt idx="0">
                  <c:v>4DA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nalysis!$BF$25:$BF$28</c:f>
                <c:numCache>
                  <c:formatCode>General</c:formatCode>
                  <c:ptCount val="4"/>
                  <c:pt idx="0">
                    <c:v>8.0966445861590366E-2</c:v>
                  </c:pt>
                  <c:pt idx="1">
                    <c:v>0.11538829440140874</c:v>
                  </c:pt>
                  <c:pt idx="2">
                    <c:v>0.115070880483246</c:v>
                  </c:pt>
                  <c:pt idx="3">
                    <c:v>0.38795810158830868</c:v>
                  </c:pt>
                </c:numCache>
              </c:numRef>
            </c:plus>
            <c:minus>
              <c:numRef>
                <c:f>Analysis!$BF$25:$BF$28</c:f>
                <c:numCache>
                  <c:formatCode>General</c:formatCode>
                  <c:ptCount val="4"/>
                  <c:pt idx="0">
                    <c:v>8.0966445861590366E-2</c:v>
                  </c:pt>
                  <c:pt idx="1">
                    <c:v>0.11538829440140874</c:v>
                  </c:pt>
                  <c:pt idx="2">
                    <c:v>0.115070880483246</c:v>
                  </c:pt>
                  <c:pt idx="3">
                    <c:v>0.3879581015883086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nalysis!$BB$25:$BB$28</c:f>
              <c:strCache>
                <c:ptCount val="4"/>
                <c:pt idx="0">
                  <c:v>Ovary</c:v>
                </c:pt>
                <c:pt idx="1">
                  <c:v>Style</c:v>
                </c:pt>
                <c:pt idx="2">
                  <c:v>Anther</c:v>
                </c:pt>
                <c:pt idx="3">
                  <c:v>Petal</c:v>
                </c:pt>
              </c:strCache>
            </c:strRef>
          </c:cat>
          <c:val>
            <c:numRef>
              <c:f>Analysis!$BD$25:$BD$28</c:f>
              <c:numCache>
                <c:formatCode>General</c:formatCode>
                <c:ptCount val="4"/>
                <c:pt idx="0">
                  <c:v>0.71208794781513607</c:v>
                </c:pt>
                <c:pt idx="1">
                  <c:v>0.48121268187222771</c:v>
                </c:pt>
                <c:pt idx="2">
                  <c:v>1.5924514666990623</c:v>
                </c:pt>
                <c:pt idx="3">
                  <c:v>21.1223961777590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7A5-4743-B6A3-14806F55DB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53519720"/>
        <c:axId val="653520376"/>
      </c:barChart>
      <c:catAx>
        <c:axId val="653519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53520376"/>
        <c:crosses val="autoZero"/>
        <c:auto val="1"/>
        <c:lblAlgn val="ctr"/>
        <c:lblOffset val="100"/>
        <c:noMultiLvlLbl val="0"/>
      </c:catAx>
      <c:valAx>
        <c:axId val="65352037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535197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5935534160318119E-2"/>
          <c:y val="6.7188888888888867E-2"/>
          <c:w val="0.88102842778455515"/>
          <c:h val="0.8287852183291293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Analysis!$BC$36</c:f>
              <c:strCache>
                <c:ptCount val="1"/>
                <c:pt idx="0">
                  <c:v>2DB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nalysis!$BE$37:$BE$40</c:f>
                <c:numCache>
                  <c:formatCode>General</c:formatCode>
                  <c:ptCount val="4"/>
                  <c:pt idx="0">
                    <c:v>0.66584124594262639</c:v>
                  </c:pt>
                  <c:pt idx="1">
                    <c:v>1.0110885949785641E-3</c:v>
                  </c:pt>
                  <c:pt idx="2">
                    <c:v>9.0827120046767251E-4</c:v>
                  </c:pt>
                  <c:pt idx="3">
                    <c:v>0.12396794183617792</c:v>
                  </c:pt>
                </c:numCache>
              </c:numRef>
            </c:plus>
            <c:minus>
              <c:numRef>
                <c:f>Analysis!$BE$37:$BE$40</c:f>
                <c:numCache>
                  <c:formatCode>General</c:formatCode>
                  <c:ptCount val="4"/>
                  <c:pt idx="0">
                    <c:v>0.66584124594262639</c:v>
                  </c:pt>
                  <c:pt idx="1">
                    <c:v>1.0110885949785641E-3</c:v>
                  </c:pt>
                  <c:pt idx="2">
                    <c:v>9.0827120046767251E-4</c:v>
                  </c:pt>
                  <c:pt idx="3">
                    <c:v>0.1239679418361779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nalysis!$BB$37:$BB$40</c:f>
              <c:strCache>
                <c:ptCount val="4"/>
                <c:pt idx="0">
                  <c:v>Ovary</c:v>
                </c:pt>
                <c:pt idx="1">
                  <c:v>Style</c:v>
                </c:pt>
                <c:pt idx="2">
                  <c:v>Anther</c:v>
                </c:pt>
                <c:pt idx="3">
                  <c:v>Petal</c:v>
                </c:pt>
              </c:strCache>
            </c:strRef>
          </c:cat>
          <c:val>
            <c:numRef>
              <c:f>Analysis!$BC$37:$BC$40</c:f>
              <c:numCache>
                <c:formatCode>General</c:formatCode>
                <c:ptCount val="4"/>
                <c:pt idx="0">
                  <c:v>4.6217661669821863</c:v>
                </c:pt>
                <c:pt idx="1">
                  <c:v>3.6111511570946732E-3</c:v>
                </c:pt>
                <c:pt idx="2">
                  <c:v>3.9632523018008148E-3</c:v>
                </c:pt>
                <c:pt idx="3">
                  <c:v>0.232561736469982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F6A-4A35-A4EF-53B984360CA6}"/>
            </c:ext>
          </c:extLst>
        </c:ser>
        <c:ser>
          <c:idx val="1"/>
          <c:order val="1"/>
          <c:tx>
            <c:strRef>
              <c:f>Analysis!$BD$36</c:f>
              <c:strCache>
                <c:ptCount val="1"/>
                <c:pt idx="0">
                  <c:v>4DA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nalysis!$BF$37:$BF$40</c:f>
                <c:numCache>
                  <c:formatCode>General</c:formatCode>
                  <c:ptCount val="4"/>
                  <c:pt idx="0">
                    <c:v>0.75429343659342885</c:v>
                  </c:pt>
                  <c:pt idx="1">
                    <c:v>8.0661057445059975E-4</c:v>
                  </c:pt>
                  <c:pt idx="2">
                    <c:v>1.3593099668566321E-2</c:v>
                  </c:pt>
                  <c:pt idx="3">
                    <c:v>0.13266091403360913</c:v>
                  </c:pt>
                </c:numCache>
              </c:numRef>
            </c:plus>
            <c:minus>
              <c:numRef>
                <c:f>Analysis!$BF$37:$BF$40</c:f>
                <c:numCache>
                  <c:formatCode>General</c:formatCode>
                  <c:ptCount val="4"/>
                  <c:pt idx="0">
                    <c:v>0.75429343659342885</c:v>
                  </c:pt>
                  <c:pt idx="1">
                    <c:v>8.0661057445059975E-4</c:v>
                  </c:pt>
                  <c:pt idx="2">
                    <c:v>1.3593099668566321E-2</c:v>
                  </c:pt>
                  <c:pt idx="3">
                    <c:v>0.1326609140336091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nalysis!$BB$37:$BB$40</c:f>
              <c:strCache>
                <c:ptCount val="4"/>
                <c:pt idx="0">
                  <c:v>Ovary</c:v>
                </c:pt>
                <c:pt idx="1">
                  <c:v>Style</c:v>
                </c:pt>
                <c:pt idx="2">
                  <c:v>Anther</c:v>
                </c:pt>
                <c:pt idx="3">
                  <c:v>Petal</c:v>
                </c:pt>
              </c:strCache>
            </c:strRef>
          </c:cat>
          <c:val>
            <c:numRef>
              <c:f>Analysis!$BD$37:$BD$40</c:f>
              <c:numCache>
                <c:formatCode>General</c:formatCode>
                <c:ptCount val="4"/>
                <c:pt idx="0">
                  <c:v>2.2988002097556404</c:v>
                </c:pt>
                <c:pt idx="1">
                  <c:v>2.8472613321362892E-3</c:v>
                </c:pt>
                <c:pt idx="2">
                  <c:v>4.0385988813042777E-2</c:v>
                </c:pt>
                <c:pt idx="3">
                  <c:v>1.39266592471850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F6A-4A35-A4EF-53B984360CA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60636072"/>
        <c:axId val="652256552"/>
      </c:barChart>
      <c:catAx>
        <c:axId val="6606360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52256552"/>
        <c:crosses val="autoZero"/>
        <c:auto val="1"/>
        <c:lblAlgn val="ctr"/>
        <c:lblOffset val="100"/>
        <c:noMultiLvlLbl val="0"/>
      </c:catAx>
      <c:valAx>
        <c:axId val="65225655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606360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4027437613570949E-2"/>
          <c:y val="8.0031417103142155E-2"/>
          <c:w val="0.86655427139648533"/>
          <c:h val="0.6595981852986164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Analysis!$BC$46</c:f>
              <c:strCache>
                <c:ptCount val="1"/>
                <c:pt idx="0">
                  <c:v>2DB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nalysis!$BE$47:$BE$50</c:f>
                <c:numCache>
                  <c:formatCode>General</c:formatCode>
                  <c:ptCount val="4"/>
                  <c:pt idx="0">
                    <c:v>1.8472006457115817E-2</c:v>
                  </c:pt>
                  <c:pt idx="1">
                    <c:v>0.26050685023831727</c:v>
                  </c:pt>
                  <c:pt idx="2">
                    <c:v>0.11307595089935715</c:v>
                  </c:pt>
                  <c:pt idx="3">
                    <c:v>6.4117404184874174E-2</c:v>
                  </c:pt>
                </c:numCache>
              </c:numRef>
            </c:plus>
            <c:minus>
              <c:numRef>
                <c:f>Analysis!$BE$47:$BE$50</c:f>
                <c:numCache>
                  <c:formatCode>General</c:formatCode>
                  <c:ptCount val="4"/>
                  <c:pt idx="0">
                    <c:v>1.8472006457115817E-2</c:v>
                  </c:pt>
                  <c:pt idx="1">
                    <c:v>0.26050685023831727</c:v>
                  </c:pt>
                  <c:pt idx="2">
                    <c:v>0.11307595089935715</c:v>
                  </c:pt>
                  <c:pt idx="3">
                    <c:v>6.411740418487417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nalysis!$BB$47:$BB$50</c:f>
              <c:strCache>
                <c:ptCount val="4"/>
                <c:pt idx="0">
                  <c:v>Ovary</c:v>
                </c:pt>
                <c:pt idx="1">
                  <c:v>Style</c:v>
                </c:pt>
                <c:pt idx="2">
                  <c:v>Anther</c:v>
                </c:pt>
                <c:pt idx="3">
                  <c:v>Petal</c:v>
                </c:pt>
              </c:strCache>
            </c:strRef>
          </c:cat>
          <c:val>
            <c:numRef>
              <c:f>Analysis!$BC$47:$BC$50</c:f>
              <c:numCache>
                <c:formatCode>General</c:formatCode>
                <c:ptCount val="4"/>
                <c:pt idx="0">
                  <c:v>0.1856954255008951</c:v>
                </c:pt>
                <c:pt idx="1">
                  <c:v>1.9398367991962968</c:v>
                </c:pt>
                <c:pt idx="2">
                  <c:v>0.48140324821910385</c:v>
                </c:pt>
                <c:pt idx="3">
                  <c:v>0.339274174441874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A3F-4D89-8352-74996C8E2DC0}"/>
            </c:ext>
          </c:extLst>
        </c:ser>
        <c:ser>
          <c:idx val="1"/>
          <c:order val="1"/>
          <c:tx>
            <c:strRef>
              <c:f>Analysis!$BD$46</c:f>
              <c:strCache>
                <c:ptCount val="1"/>
                <c:pt idx="0">
                  <c:v>4DA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nalysis!$BF$47:$BF$50</c:f>
                <c:numCache>
                  <c:formatCode>General</c:formatCode>
                  <c:ptCount val="4"/>
                  <c:pt idx="0">
                    <c:v>9.7486106705060235E-3</c:v>
                  </c:pt>
                  <c:pt idx="1">
                    <c:v>0.14517069749339639</c:v>
                  </c:pt>
                  <c:pt idx="2">
                    <c:v>0.24120814155856507</c:v>
                  </c:pt>
                  <c:pt idx="3">
                    <c:v>1.9328568795865531E-2</c:v>
                  </c:pt>
                </c:numCache>
              </c:numRef>
            </c:plus>
            <c:minus>
              <c:numRef>
                <c:f>Analysis!$BF$47:$BF$50</c:f>
                <c:numCache>
                  <c:formatCode>General</c:formatCode>
                  <c:ptCount val="4"/>
                  <c:pt idx="0">
                    <c:v>9.7486106705060235E-3</c:v>
                  </c:pt>
                  <c:pt idx="1">
                    <c:v>0.14517069749339639</c:v>
                  </c:pt>
                  <c:pt idx="2">
                    <c:v>0.24120814155856507</c:v>
                  </c:pt>
                  <c:pt idx="3">
                    <c:v>1.932856879586553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nalysis!$BB$47:$BB$50</c:f>
              <c:strCache>
                <c:ptCount val="4"/>
                <c:pt idx="0">
                  <c:v>Ovary</c:v>
                </c:pt>
                <c:pt idx="1">
                  <c:v>Style</c:v>
                </c:pt>
                <c:pt idx="2">
                  <c:v>Anther</c:v>
                </c:pt>
                <c:pt idx="3">
                  <c:v>Petal</c:v>
                </c:pt>
              </c:strCache>
            </c:strRef>
          </c:cat>
          <c:val>
            <c:numRef>
              <c:f>Analysis!$BD$47:$BD$50</c:f>
              <c:numCache>
                <c:formatCode>General</c:formatCode>
                <c:ptCount val="4"/>
                <c:pt idx="0">
                  <c:v>0.12699599025266273</c:v>
                </c:pt>
                <c:pt idx="1">
                  <c:v>3.3400144967947494</c:v>
                </c:pt>
                <c:pt idx="2">
                  <c:v>0.6984198460944322</c:v>
                </c:pt>
                <c:pt idx="3">
                  <c:v>0.16363522507380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A3F-4D89-8352-74996C8E2DC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52254912"/>
        <c:axId val="652257536"/>
      </c:barChart>
      <c:catAx>
        <c:axId val="6522549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52257536"/>
        <c:crosses val="autoZero"/>
        <c:auto val="1"/>
        <c:lblAlgn val="ctr"/>
        <c:lblOffset val="100"/>
        <c:noMultiLvlLbl val="0"/>
      </c:catAx>
      <c:valAx>
        <c:axId val="65225753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522549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DE520B-E01C-482F-A4E8-8DD949757620}" type="datetimeFigureOut">
              <a:rPr lang="zh-CN" altLang="en-US" smtClean="0"/>
              <a:t>2019/3/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7AC6637-F3F0-4B24-9193-6F83C939A3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17748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7AC6637-F3F0-4B24-9193-6F83C939A35F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910308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7AC6637-F3F0-4B24-9193-6F83C939A35F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54138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E7CB6-AE66-48EB-9808-E1FC23F6920E}" type="datetimeFigureOut">
              <a:rPr lang="zh-CN" altLang="en-US" smtClean="0"/>
              <a:t>2019/3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4193B-93FA-46FD-8839-2F9A1F40A4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54671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E7CB6-AE66-48EB-9808-E1FC23F6920E}" type="datetimeFigureOut">
              <a:rPr lang="zh-CN" altLang="en-US" smtClean="0"/>
              <a:t>2019/3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4193B-93FA-46FD-8839-2F9A1F40A4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92725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E7CB6-AE66-48EB-9808-E1FC23F6920E}" type="datetimeFigureOut">
              <a:rPr lang="zh-CN" altLang="en-US" smtClean="0"/>
              <a:t>2019/3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4193B-93FA-46FD-8839-2F9A1F40A4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33276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E7CB6-AE66-48EB-9808-E1FC23F6920E}" type="datetimeFigureOut">
              <a:rPr lang="zh-CN" altLang="en-US" smtClean="0"/>
              <a:t>2019/3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4193B-93FA-46FD-8839-2F9A1F40A4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35883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E7CB6-AE66-48EB-9808-E1FC23F6920E}" type="datetimeFigureOut">
              <a:rPr lang="zh-CN" altLang="en-US" smtClean="0"/>
              <a:t>2019/3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4193B-93FA-46FD-8839-2F9A1F40A4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60230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E7CB6-AE66-48EB-9808-E1FC23F6920E}" type="datetimeFigureOut">
              <a:rPr lang="zh-CN" altLang="en-US" smtClean="0"/>
              <a:t>2019/3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4193B-93FA-46FD-8839-2F9A1F40A4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12583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E7CB6-AE66-48EB-9808-E1FC23F6920E}" type="datetimeFigureOut">
              <a:rPr lang="zh-CN" altLang="en-US" smtClean="0"/>
              <a:t>2019/3/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4193B-93FA-46FD-8839-2F9A1F40A4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349662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E7CB6-AE66-48EB-9808-E1FC23F6920E}" type="datetimeFigureOut">
              <a:rPr lang="zh-CN" altLang="en-US" smtClean="0"/>
              <a:t>2019/3/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4193B-93FA-46FD-8839-2F9A1F40A4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97779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E7CB6-AE66-48EB-9808-E1FC23F6920E}" type="datetimeFigureOut">
              <a:rPr lang="zh-CN" altLang="en-US" smtClean="0"/>
              <a:t>2019/3/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4193B-93FA-46FD-8839-2F9A1F40A4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67703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E7CB6-AE66-48EB-9808-E1FC23F6920E}" type="datetimeFigureOut">
              <a:rPr lang="zh-CN" altLang="en-US" smtClean="0"/>
              <a:t>2019/3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4193B-93FA-46FD-8839-2F9A1F40A4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61897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E7CB6-AE66-48EB-9808-E1FC23F6920E}" type="datetimeFigureOut">
              <a:rPr lang="zh-CN" altLang="en-US" smtClean="0"/>
              <a:t>2019/3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4193B-93FA-46FD-8839-2F9A1F40A4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39884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CE7CB6-AE66-48EB-9808-E1FC23F6920E}" type="datetimeFigureOut">
              <a:rPr lang="zh-CN" altLang="en-US" smtClean="0"/>
              <a:t>2019/3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74193B-93FA-46FD-8839-2F9A1F40A4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9099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g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7" Type="http://schemas.openxmlformats.org/officeDocument/2006/relationships/chart" Target="../charts/chart8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7.xml"/><Relationship Id="rId5" Type="http://schemas.openxmlformats.org/officeDocument/2006/relationships/chart" Target="../charts/chart6.xml"/><Relationship Id="rId4" Type="http://schemas.openxmlformats.org/officeDocument/2006/relationships/chart" Target="../charts/char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图表 3">
            <a:extLst>
              <a:ext uri="{FF2B5EF4-FFF2-40B4-BE49-F238E27FC236}">
                <a16:creationId xmlns:a16="http://schemas.microsoft.com/office/drawing/2014/main" id="{F8DF423D-A3D6-4D94-A946-753ABD772E4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16763804"/>
              </p:ext>
            </p:extLst>
          </p:nvPr>
        </p:nvGraphicFramePr>
        <p:xfrm>
          <a:off x="1683257" y="1464321"/>
          <a:ext cx="3362199" cy="18311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图表 4">
            <a:extLst>
              <a:ext uri="{FF2B5EF4-FFF2-40B4-BE49-F238E27FC236}">
                <a16:creationId xmlns:a16="http://schemas.microsoft.com/office/drawing/2014/main" id="{D93D5945-0F4F-4D62-B6AF-D646C562694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63528370"/>
              </p:ext>
            </p:extLst>
          </p:nvPr>
        </p:nvGraphicFramePr>
        <p:xfrm>
          <a:off x="1677161" y="3171626"/>
          <a:ext cx="3362199" cy="170114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" name="图表 2">
            <a:extLst>
              <a:ext uri="{FF2B5EF4-FFF2-40B4-BE49-F238E27FC236}">
                <a16:creationId xmlns:a16="http://schemas.microsoft.com/office/drawing/2014/main" id="{047E721B-361B-4DF1-B834-B7C6A694171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99179789"/>
              </p:ext>
            </p:extLst>
          </p:nvPr>
        </p:nvGraphicFramePr>
        <p:xfrm>
          <a:off x="1622958" y="-64957"/>
          <a:ext cx="3422498" cy="20283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" name="矩形 5">
            <a:extLst>
              <a:ext uri="{FF2B5EF4-FFF2-40B4-BE49-F238E27FC236}">
                <a16:creationId xmlns:a16="http://schemas.microsoft.com/office/drawing/2014/main" id="{9A8D80ED-BEBC-43B2-BAF5-374875707AB2}"/>
              </a:ext>
            </a:extLst>
          </p:cNvPr>
          <p:cNvSpPr/>
          <p:nvPr/>
        </p:nvSpPr>
        <p:spPr>
          <a:xfrm rot="16200000">
            <a:off x="738249" y="2332533"/>
            <a:ext cx="17251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400" b="0" i="0" u="none" strike="noStrike" kern="120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altLang="zh-CN" sz="1200" dirty="0">
                <a:solidFill>
                  <a:schemeClr val="tx1">
                    <a:lumMod val="85000"/>
                    <a:lumOff val="15000"/>
                  </a:schemeClr>
                </a:solidFill>
              </a:rPr>
              <a:t>Relative gene expression</a:t>
            </a:r>
            <a:endParaRPr lang="zh-CN" altLang="en-US" sz="1200" dirty="0">
              <a:solidFill>
                <a:schemeClr val="tx1">
                  <a:lumMod val="85000"/>
                  <a:lumOff val="15000"/>
                </a:schemeClr>
              </a:solidFill>
            </a:endParaRPr>
          </a:p>
        </p:txBody>
      </p:sp>
      <p:sp>
        <p:nvSpPr>
          <p:cNvPr id="7" name="文本框 1">
            <a:extLst>
              <a:ext uri="{FF2B5EF4-FFF2-40B4-BE49-F238E27FC236}">
                <a16:creationId xmlns:a16="http://schemas.microsoft.com/office/drawing/2014/main" id="{2CBA52D7-6048-4532-8EC0-2E0E9A0D37A6}"/>
              </a:ext>
            </a:extLst>
          </p:cNvPr>
          <p:cNvSpPr txBox="1"/>
          <p:nvPr/>
        </p:nvSpPr>
        <p:spPr>
          <a:xfrm>
            <a:off x="3703780" y="760585"/>
            <a:ext cx="392198" cy="2112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/>
              <a:t>***</a:t>
            </a:r>
            <a:endParaRPr lang="zh-CN" altLang="en-US" sz="1100" dirty="0"/>
          </a:p>
        </p:txBody>
      </p:sp>
      <p:sp>
        <p:nvSpPr>
          <p:cNvPr id="8" name="文本框 1">
            <a:extLst>
              <a:ext uri="{FF2B5EF4-FFF2-40B4-BE49-F238E27FC236}">
                <a16:creationId xmlns:a16="http://schemas.microsoft.com/office/drawing/2014/main" id="{420E5B67-BEED-4AA1-A851-EEC19F68C4D3}"/>
              </a:ext>
            </a:extLst>
          </p:cNvPr>
          <p:cNvSpPr txBox="1"/>
          <p:nvPr/>
        </p:nvSpPr>
        <p:spPr>
          <a:xfrm>
            <a:off x="4466398" y="447353"/>
            <a:ext cx="47136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/>
              <a:t>**</a:t>
            </a:r>
            <a:endParaRPr lang="zh-CN" altLang="en-US" sz="1100" dirty="0"/>
          </a:p>
        </p:txBody>
      </p:sp>
      <p:sp>
        <p:nvSpPr>
          <p:cNvPr id="9" name="文本框 1">
            <a:extLst>
              <a:ext uri="{FF2B5EF4-FFF2-40B4-BE49-F238E27FC236}">
                <a16:creationId xmlns:a16="http://schemas.microsoft.com/office/drawing/2014/main" id="{F8CA6BF2-4488-497B-892B-B72186A11CB2}"/>
              </a:ext>
            </a:extLst>
          </p:cNvPr>
          <p:cNvSpPr txBox="1"/>
          <p:nvPr/>
        </p:nvSpPr>
        <p:spPr>
          <a:xfrm>
            <a:off x="2238942" y="2958498"/>
            <a:ext cx="392198" cy="2112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/>
              <a:t>***</a:t>
            </a:r>
            <a:endParaRPr lang="zh-CN" altLang="en-US" sz="1100" dirty="0"/>
          </a:p>
        </p:txBody>
      </p:sp>
      <p:sp>
        <p:nvSpPr>
          <p:cNvPr id="10" name="文本框 1">
            <a:extLst>
              <a:ext uri="{FF2B5EF4-FFF2-40B4-BE49-F238E27FC236}">
                <a16:creationId xmlns:a16="http://schemas.microsoft.com/office/drawing/2014/main" id="{DC43A38C-7C67-40A4-A048-F967E3B5F63F}"/>
              </a:ext>
            </a:extLst>
          </p:cNvPr>
          <p:cNvSpPr txBox="1"/>
          <p:nvPr/>
        </p:nvSpPr>
        <p:spPr>
          <a:xfrm>
            <a:off x="3005721" y="2910065"/>
            <a:ext cx="322390" cy="2112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/>
              <a:t>**</a:t>
            </a:r>
            <a:endParaRPr lang="zh-CN" altLang="en-US" sz="1100" dirty="0"/>
          </a:p>
        </p:txBody>
      </p:sp>
      <p:sp>
        <p:nvSpPr>
          <p:cNvPr id="11" name="文本框 1">
            <a:extLst>
              <a:ext uri="{FF2B5EF4-FFF2-40B4-BE49-F238E27FC236}">
                <a16:creationId xmlns:a16="http://schemas.microsoft.com/office/drawing/2014/main" id="{0F2E3809-B3D7-4164-93E2-FCFF9E23FDFF}"/>
              </a:ext>
            </a:extLst>
          </p:cNvPr>
          <p:cNvSpPr txBox="1"/>
          <p:nvPr/>
        </p:nvSpPr>
        <p:spPr>
          <a:xfrm>
            <a:off x="3713776" y="2826580"/>
            <a:ext cx="392198" cy="2112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/>
              <a:t>***</a:t>
            </a:r>
            <a:endParaRPr lang="zh-CN" altLang="en-US" sz="1100" dirty="0"/>
          </a:p>
        </p:txBody>
      </p:sp>
      <p:sp>
        <p:nvSpPr>
          <p:cNvPr id="12" name="文本框 1">
            <a:extLst>
              <a:ext uri="{FF2B5EF4-FFF2-40B4-BE49-F238E27FC236}">
                <a16:creationId xmlns:a16="http://schemas.microsoft.com/office/drawing/2014/main" id="{7E621818-849D-453F-8038-89BAECD600CF}"/>
              </a:ext>
            </a:extLst>
          </p:cNvPr>
          <p:cNvSpPr txBox="1"/>
          <p:nvPr/>
        </p:nvSpPr>
        <p:spPr>
          <a:xfrm flipV="1">
            <a:off x="4389409" y="2011828"/>
            <a:ext cx="4361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/>
              <a:t>***</a:t>
            </a:r>
            <a:endParaRPr lang="zh-CN" altLang="en-US" sz="1100" dirty="0"/>
          </a:p>
        </p:txBody>
      </p:sp>
      <p:sp>
        <p:nvSpPr>
          <p:cNvPr id="13" name="文本框 1">
            <a:extLst>
              <a:ext uri="{FF2B5EF4-FFF2-40B4-BE49-F238E27FC236}">
                <a16:creationId xmlns:a16="http://schemas.microsoft.com/office/drawing/2014/main" id="{BB5E5DE1-62CE-441F-AB69-A270446B1516}"/>
              </a:ext>
            </a:extLst>
          </p:cNvPr>
          <p:cNvSpPr txBox="1"/>
          <p:nvPr/>
        </p:nvSpPr>
        <p:spPr>
          <a:xfrm flipV="1">
            <a:off x="3657735" y="3343536"/>
            <a:ext cx="4931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b="1" dirty="0"/>
              <a:t>***</a:t>
            </a:r>
            <a:endParaRPr lang="zh-CN" altLang="en-US" sz="1100" b="1" dirty="0"/>
          </a:p>
        </p:txBody>
      </p:sp>
      <p:sp>
        <p:nvSpPr>
          <p:cNvPr id="14" name="文本框 1">
            <a:extLst>
              <a:ext uri="{FF2B5EF4-FFF2-40B4-BE49-F238E27FC236}">
                <a16:creationId xmlns:a16="http://schemas.microsoft.com/office/drawing/2014/main" id="{06D72D3F-0EFA-42E7-A257-C276609B55F2}"/>
              </a:ext>
            </a:extLst>
          </p:cNvPr>
          <p:cNvSpPr txBox="1"/>
          <p:nvPr/>
        </p:nvSpPr>
        <p:spPr>
          <a:xfrm>
            <a:off x="4537783" y="3771978"/>
            <a:ext cx="322390" cy="2112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/>
              <a:t>**</a:t>
            </a:r>
            <a:endParaRPr lang="zh-CN" altLang="en-US" sz="1100" dirty="0"/>
          </a:p>
        </p:txBody>
      </p:sp>
      <p:sp>
        <p:nvSpPr>
          <p:cNvPr id="17" name="文本框 6">
            <a:extLst>
              <a:ext uri="{FF2B5EF4-FFF2-40B4-BE49-F238E27FC236}">
                <a16:creationId xmlns:a16="http://schemas.microsoft.com/office/drawing/2014/main" id="{90A17A4A-A61A-4F8B-8776-C9690AD21DCA}"/>
              </a:ext>
            </a:extLst>
          </p:cNvPr>
          <p:cNvSpPr txBox="1"/>
          <p:nvPr/>
        </p:nvSpPr>
        <p:spPr>
          <a:xfrm>
            <a:off x="665347" y="4824734"/>
            <a:ext cx="588724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1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Relative expression of hexose transporter genes,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lHT1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lHT2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lHT3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in different flower tissues of tomato at 2 days before (2DBA) and 4 days after anthesis (4DAA). Asterisks indicate significant differences (Student’s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-test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*, p&lt;0.05; **, p&lt;0.01; ***, p&lt;0.001, n=4) between 2DBA and 4DAA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867458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文本框 6">
            <a:extLst>
              <a:ext uri="{FF2B5EF4-FFF2-40B4-BE49-F238E27FC236}">
                <a16:creationId xmlns:a16="http://schemas.microsoft.com/office/drawing/2014/main" id="{66CEC84D-DBB1-46A7-9B92-F3C397B5E278}"/>
              </a:ext>
            </a:extLst>
          </p:cNvPr>
          <p:cNvSpPr txBox="1"/>
          <p:nvPr/>
        </p:nvSpPr>
        <p:spPr>
          <a:xfrm>
            <a:off x="224910" y="5969034"/>
            <a:ext cx="638163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2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ylogenetic analysis of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lSWEET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amilies in tomato in relation to Arabidopsis. </a:t>
            </a:r>
          </a:p>
          <a:p>
            <a:pPr algn="just"/>
            <a:endParaRPr lang="en-US" altLang="zh-CN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d on the current knowledge, SWEETs in Clade I and Clade II transport hexoses; while those in Clade III transport sucrose, all are predicted to located on plasma membrane. SWEETs in Clade IV are located on tonoplast to transport hexose.</a:t>
            </a:r>
          </a:p>
        </p:txBody>
      </p:sp>
      <p:grpSp>
        <p:nvGrpSpPr>
          <p:cNvPr id="21" name="组合 20">
            <a:extLst>
              <a:ext uri="{FF2B5EF4-FFF2-40B4-BE49-F238E27FC236}">
                <a16:creationId xmlns:a16="http://schemas.microsoft.com/office/drawing/2014/main" id="{7544F0A6-9E70-4AD0-B30F-99224497A7C9}"/>
              </a:ext>
            </a:extLst>
          </p:cNvPr>
          <p:cNvGrpSpPr/>
          <p:nvPr/>
        </p:nvGrpSpPr>
        <p:grpSpPr>
          <a:xfrm>
            <a:off x="1021080" y="88900"/>
            <a:ext cx="5001939" cy="5846098"/>
            <a:chOff x="60960" y="111760"/>
            <a:chExt cx="5001939" cy="5846098"/>
          </a:xfrm>
        </p:grpSpPr>
        <p:sp>
          <p:nvSpPr>
            <p:cNvPr id="8" name="矩形 7">
              <a:extLst>
                <a:ext uri="{FF2B5EF4-FFF2-40B4-BE49-F238E27FC236}">
                  <a16:creationId xmlns:a16="http://schemas.microsoft.com/office/drawing/2014/main" id="{6E32BC87-DE9E-4A31-84FC-931213527DD4}"/>
                </a:ext>
              </a:extLst>
            </p:cNvPr>
            <p:cNvSpPr/>
            <p:nvPr/>
          </p:nvSpPr>
          <p:spPr>
            <a:xfrm>
              <a:off x="294290" y="1865376"/>
              <a:ext cx="3777838" cy="1572768"/>
            </a:xfrm>
            <a:prstGeom prst="rect">
              <a:avLst/>
            </a:prstGeom>
            <a:solidFill>
              <a:schemeClr val="accent5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E0A7D21F-644F-4E4F-BC13-0EC5E3232FE5}"/>
                </a:ext>
              </a:extLst>
            </p:cNvPr>
            <p:cNvSpPr/>
            <p:nvPr/>
          </p:nvSpPr>
          <p:spPr>
            <a:xfrm>
              <a:off x="294290" y="3434080"/>
              <a:ext cx="3777838" cy="652272"/>
            </a:xfrm>
            <a:prstGeom prst="rect">
              <a:avLst/>
            </a:prstGeom>
            <a:solidFill>
              <a:srgbClr val="FFCC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" name="矩形 9">
              <a:extLst>
                <a:ext uri="{FF2B5EF4-FFF2-40B4-BE49-F238E27FC236}">
                  <a16:creationId xmlns:a16="http://schemas.microsoft.com/office/drawing/2014/main" id="{DC1DCFF9-96A2-4D84-8D1B-B8BE0BC99BAD}"/>
                </a:ext>
              </a:extLst>
            </p:cNvPr>
            <p:cNvSpPr/>
            <p:nvPr/>
          </p:nvSpPr>
          <p:spPr>
            <a:xfrm>
              <a:off x="294290" y="4077208"/>
              <a:ext cx="3777838" cy="1880650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60286123-ADEF-4F1B-A4DF-2303EA3F719B}"/>
                </a:ext>
              </a:extLst>
            </p:cNvPr>
            <p:cNvSpPr/>
            <p:nvPr/>
          </p:nvSpPr>
          <p:spPr>
            <a:xfrm>
              <a:off x="294290" y="111760"/>
              <a:ext cx="3777838" cy="1753616"/>
            </a:xfrm>
            <a:prstGeom prst="rect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92B09EC4-0DA4-40DF-A576-AA9212F724F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960" y="122936"/>
              <a:ext cx="4096512" cy="5834922"/>
            </a:xfrm>
            <a:prstGeom prst="rect">
              <a:avLst/>
            </a:prstGeom>
          </p:spPr>
        </p:pic>
        <p:sp>
          <p:nvSpPr>
            <p:cNvPr id="13" name="右大括号 12">
              <a:extLst>
                <a:ext uri="{FF2B5EF4-FFF2-40B4-BE49-F238E27FC236}">
                  <a16:creationId xmlns:a16="http://schemas.microsoft.com/office/drawing/2014/main" id="{5744D145-8331-4D82-A73A-D94B2CD6EBE4}"/>
                </a:ext>
              </a:extLst>
            </p:cNvPr>
            <p:cNvSpPr/>
            <p:nvPr/>
          </p:nvSpPr>
          <p:spPr>
            <a:xfrm>
              <a:off x="4068504" y="119616"/>
              <a:ext cx="179646" cy="1734329"/>
            </a:xfrm>
            <a:prstGeom prst="rightBrac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12700">
              <a:solidFill>
                <a:schemeClr val="accent6">
                  <a:lumMod val="40000"/>
                  <a:lumOff val="6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" name="右大括号 13">
              <a:extLst>
                <a:ext uri="{FF2B5EF4-FFF2-40B4-BE49-F238E27FC236}">
                  <a16:creationId xmlns:a16="http://schemas.microsoft.com/office/drawing/2014/main" id="{27A88ADE-46AA-446B-B5C1-18AAE8713E75}"/>
                </a:ext>
              </a:extLst>
            </p:cNvPr>
            <p:cNvSpPr/>
            <p:nvPr/>
          </p:nvSpPr>
          <p:spPr>
            <a:xfrm>
              <a:off x="4069712" y="1872507"/>
              <a:ext cx="179646" cy="1544556"/>
            </a:xfrm>
            <a:prstGeom prst="rightBrace">
              <a:avLst/>
            </a:prstGeom>
            <a:solidFill>
              <a:schemeClr val="accent5">
                <a:lumMod val="40000"/>
                <a:lumOff val="60000"/>
              </a:schemeClr>
            </a:solidFill>
            <a:ln w="12700"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15" name="右大括号 14">
              <a:extLst>
                <a:ext uri="{FF2B5EF4-FFF2-40B4-BE49-F238E27FC236}">
                  <a16:creationId xmlns:a16="http://schemas.microsoft.com/office/drawing/2014/main" id="{3D194EDD-D6FA-496C-8697-72B9EFC8171B}"/>
                </a:ext>
              </a:extLst>
            </p:cNvPr>
            <p:cNvSpPr/>
            <p:nvPr/>
          </p:nvSpPr>
          <p:spPr>
            <a:xfrm>
              <a:off x="4069712" y="3429164"/>
              <a:ext cx="178438" cy="648044"/>
            </a:xfrm>
            <a:prstGeom prst="rightBrace">
              <a:avLst/>
            </a:prstGeom>
            <a:solidFill>
              <a:srgbClr val="FFCCFF"/>
            </a:solidFill>
            <a:ln w="12700">
              <a:solidFill>
                <a:srgbClr val="FF97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" name="右大括号 15">
              <a:extLst>
                <a:ext uri="{FF2B5EF4-FFF2-40B4-BE49-F238E27FC236}">
                  <a16:creationId xmlns:a16="http://schemas.microsoft.com/office/drawing/2014/main" id="{7A614261-9E6F-4BB2-B38A-E866C1188A11}"/>
                </a:ext>
              </a:extLst>
            </p:cNvPr>
            <p:cNvSpPr/>
            <p:nvPr/>
          </p:nvSpPr>
          <p:spPr>
            <a:xfrm>
              <a:off x="4070920" y="4086604"/>
              <a:ext cx="203900" cy="1863633"/>
            </a:xfrm>
            <a:prstGeom prst="rightBrace">
              <a:avLst/>
            </a:prstGeom>
            <a:solidFill>
              <a:schemeClr val="accent4">
                <a:lumMod val="20000"/>
                <a:lumOff val="80000"/>
              </a:schemeClr>
            </a:solidFill>
            <a:ln w="12700">
              <a:solidFill>
                <a:srgbClr val="FDE188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EAAED8BC-5A27-4477-B3A4-E25A109B276A}"/>
                </a:ext>
              </a:extLst>
            </p:cNvPr>
            <p:cNvSpPr txBox="1"/>
            <p:nvPr/>
          </p:nvSpPr>
          <p:spPr>
            <a:xfrm>
              <a:off x="4281657" y="825271"/>
              <a:ext cx="68640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/>
                <a:t>Clade I</a:t>
              </a:r>
              <a:endParaRPr lang="zh-CN" altLang="en-US" sz="1400" b="1" dirty="0"/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4FFADD4C-9F7F-4624-9DE4-6C3A96736083}"/>
                </a:ext>
              </a:extLst>
            </p:cNvPr>
            <p:cNvSpPr txBox="1"/>
            <p:nvPr/>
          </p:nvSpPr>
          <p:spPr>
            <a:xfrm>
              <a:off x="4266417" y="2485480"/>
              <a:ext cx="7344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/>
                <a:t>Clade II</a:t>
              </a:r>
              <a:endParaRPr lang="zh-CN" altLang="en-US" sz="1400" b="1" dirty="0"/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45E0B3F0-7253-4B38-97C1-7CFAD52409F2}"/>
                </a:ext>
              </a:extLst>
            </p:cNvPr>
            <p:cNvSpPr txBox="1"/>
            <p:nvPr/>
          </p:nvSpPr>
          <p:spPr>
            <a:xfrm>
              <a:off x="4262607" y="3593354"/>
              <a:ext cx="7922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/>
                <a:t>Clade IV</a:t>
              </a:r>
              <a:endParaRPr lang="zh-CN" altLang="en-US" sz="1400" b="1" dirty="0"/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FE7015FF-F38D-4C75-ABA8-ACC470C012DA}"/>
                </a:ext>
              </a:extLst>
            </p:cNvPr>
            <p:cNvSpPr txBox="1"/>
            <p:nvPr/>
          </p:nvSpPr>
          <p:spPr>
            <a:xfrm>
              <a:off x="4280312" y="4857549"/>
              <a:ext cx="78258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/>
                <a:t>Clade III</a:t>
              </a:r>
              <a:endParaRPr lang="zh-CN" altLang="en-US" sz="14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40116480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8">
            <a:extLst>
              <a:ext uri="{FF2B5EF4-FFF2-40B4-BE49-F238E27FC236}">
                <a16:creationId xmlns:a16="http://schemas.microsoft.com/office/drawing/2014/main" id="{F67CAD76-9DF7-4105-A821-B13BD9A08F1D}"/>
              </a:ext>
            </a:extLst>
          </p:cNvPr>
          <p:cNvSpPr txBox="1"/>
          <p:nvPr/>
        </p:nvSpPr>
        <p:spPr>
          <a:xfrm rot="16200000">
            <a:off x="197503" y="2950783"/>
            <a:ext cx="23393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solidFill>
                  <a:schemeClr val="tx1">
                    <a:lumMod val="85000"/>
                    <a:lumOff val="15000"/>
                  </a:schemeClr>
                </a:solidFill>
              </a:rPr>
              <a:t>Relative gene expression</a:t>
            </a:r>
            <a:endParaRPr lang="zh-CN" altLang="en-US" sz="1600" dirty="0">
              <a:solidFill>
                <a:schemeClr val="tx1">
                  <a:lumMod val="85000"/>
                  <a:lumOff val="15000"/>
                </a:schemeClr>
              </a:solidFill>
            </a:endParaRPr>
          </a:p>
        </p:txBody>
      </p:sp>
      <p:grpSp>
        <p:nvGrpSpPr>
          <p:cNvPr id="11" name="组合 10">
            <a:extLst>
              <a:ext uri="{FF2B5EF4-FFF2-40B4-BE49-F238E27FC236}">
                <a16:creationId xmlns:a16="http://schemas.microsoft.com/office/drawing/2014/main" id="{78A7BC83-3C77-4AA3-B05B-A8703768DE88}"/>
              </a:ext>
            </a:extLst>
          </p:cNvPr>
          <p:cNvGrpSpPr/>
          <p:nvPr/>
        </p:nvGrpSpPr>
        <p:grpSpPr>
          <a:xfrm>
            <a:off x="1386898" y="320850"/>
            <a:ext cx="4207739" cy="1227526"/>
            <a:chOff x="804584" y="1500040"/>
            <a:chExt cx="3506449" cy="2534346"/>
          </a:xfrm>
        </p:grpSpPr>
        <p:graphicFrame>
          <p:nvGraphicFramePr>
            <p:cNvPr id="12" name="图表 11">
              <a:extLst>
                <a:ext uri="{FF2B5EF4-FFF2-40B4-BE49-F238E27FC236}">
                  <a16:creationId xmlns:a16="http://schemas.microsoft.com/office/drawing/2014/main" id="{5AD1BCFB-9013-4B6C-9755-DD60B9F7A8AA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30912024"/>
                </p:ext>
              </p:extLst>
            </p:nvPr>
          </p:nvGraphicFramePr>
          <p:xfrm>
            <a:off x="804584" y="1500040"/>
            <a:ext cx="3506449" cy="253434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3" name="文本框 1">
              <a:extLst>
                <a:ext uri="{FF2B5EF4-FFF2-40B4-BE49-F238E27FC236}">
                  <a16:creationId xmlns:a16="http://schemas.microsoft.com/office/drawing/2014/main" id="{D717ABF5-B3B4-4133-AE95-C1F9005E573E}"/>
                </a:ext>
              </a:extLst>
            </p:cNvPr>
            <p:cNvSpPr txBox="1"/>
            <p:nvPr/>
          </p:nvSpPr>
          <p:spPr>
            <a:xfrm>
              <a:off x="2281670" y="3288712"/>
              <a:ext cx="329007" cy="540119"/>
            </a:xfrm>
            <a:prstGeom prst="rect">
              <a:avLst/>
            </a:prstGeom>
            <a:noFill/>
          </p:spPr>
          <p:txBody>
            <a:bodyPr wrap="none" lIns="90000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dirty="0"/>
                <a:t>***</a:t>
              </a:r>
              <a:endParaRPr lang="zh-CN" altLang="en-US" sz="1100" dirty="0"/>
            </a:p>
          </p:txBody>
        </p:sp>
        <p:sp>
          <p:nvSpPr>
            <p:cNvPr id="14" name="文本框 1">
              <a:extLst>
                <a:ext uri="{FF2B5EF4-FFF2-40B4-BE49-F238E27FC236}">
                  <a16:creationId xmlns:a16="http://schemas.microsoft.com/office/drawing/2014/main" id="{31C7CA21-E67F-4E79-B4ED-9F52F32EB480}"/>
                </a:ext>
              </a:extLst>
            </p:cNvPr>
            <p:cNvSpPr txBox="1"/>
            <p:nvPr/>
          </p:nvSpPr>
          <p:spPr>
            <a:xfrm>
              <a:off x="3090246" y="1545236"/>
              <a:ext cx="270230" cy="540119"/>
            </a:xfrm>
            <a:prstGeom prst="rect">
              <a:avLst/>
            </a:prstGeom>
            <a:noFill/>
          </p:spPr>
          <p:txBody>
            <a:bodyPr wrap="none" lIns="90000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dirty="0"/>
                <a:t>**</a:t>
              </a:r>
              <a:endParaRPr lang="zh-CN" altLang="en-US" sz="1100" dirty="0"/>
            </a:p>
          </p:txBody>
        </p:sp>
      </p:grpSp>
      <p:grpSp>
        <p:nvGrpSpPr>
          <p:cNvPr id="15" name="组合 14">
            <a:extLst>
              <a:ext uri="{FF2B5EF4-FFF2-40B4-BE49-F238E27FC236}">
                <a16:creationId xmlns:a16="http://schemas.microsoft.com/office/drawing/2014/main" id="{F463185C-F860-49EE-B51A-BFD8F1583BD8}"/>
              </a:ext>
            </a:extLst>
          </p:cNvPr>
          <p:cNvGrpSpPr/>
          <p:nvPr/>
        </p:nvGrpSpPr>
        <p:grpSpPr>
          <a:xfrm>
            <a:off x="1416145" y="1679474"/>
            <a:ext cx="4320000" cy="1121930"/>
            <a:chOff x="5264296" y="208524"/>
            <a:chExt cx="3600000" cy="1366259"/>
          </a:xfrm>
        </p:grpSpPr>
        <p:graphicFrame>
          <p:nvGraphicFramePr>
            <p:cNvPr id="16" name="图表 15">
              <a:extLst>
                <a:ext uri="{FF2B5EF4-FFF2-40B4-BE49-F238E27FC236}">
                  <a16:creationId xmlns:a16="http://schemas.microsoft.com/office/drawing/2014/main" id="{3038F415-5508-4E97-A245-97CA3519249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15972590"/>
                </p:ext>
              </p:extLst>
            </p:nvPr>
          </p:nvGraphicFramePr>
          <p:xfrm>
            <a:off x="5264296" y="208524"/>
            <a:ext cx="3600000" cy="136625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7" name="文本框 1">
              <a:extLst>
                <a:ext uri="{FF2B5EF4-FFF2-40B4-BE49-F238E27FC236}">
                  <a16:creationId xmlns:a16="http://schemas.microsoft.com/office/drawing/2014/main" id="{F3B0E26C-E935-41BC-808C-04F1E97C5041}"/>
                </a:ext>
              </a:extLst>
            </p:cNvPr>
            <p:cNvSpPr txBox="1"/>
            <p:nvPr/>
          </p:nvSpPr>
          <p:spPr>
            <a:xfrm>
              <a:off x="5753330" y="540643"/>
              <a:ext cx="270230" cy="318582"/>
            </a:xfrm>
            <a:prstGeom prst="rect">
              <a:avLst/>
            </a:prstGeom>
            <a:noFill/>
          </p:spPr>
          <p:txBody>
            <a:bodyPr wrap="none" lIns="90000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dirty="0"/>
                <a:t>**</a:t>
              </a:r>
              <a:endParaRPr lang="zh-CN" altLang="en-US" sz="1100" dirty="0"/>
            </a:p>
          </p:txBody>
        </p:sp>
        <p:sp>
          <p:nvSpPr>
            <p:cNvPr id="18" name="文本框 1">
              <a:extLst>
                <a:ext uri="{FF2B5EF4-FFF2-40B4-BE49-F238E27FC236}">
                  <a16:creationId xmlns:a16="http://schemas.microsoft.com/office/drawing/2014/main" id="{8F622256-4615-4900-8B89-31F6C38A0191}"/>
                </a:ext>
              </a:extLst>
            </p:cNvPr>
            <p:cNvSpPr txBox="1"/>
            <p:nvPr/>
          </p:nvSpPr>
          <p:spPr>
            <a:xfrm>
              <a:off x="7493220" y="939141"/>
              <a:ext cx="329007" cy="318582"/>
            </a:xfrm>
            <a:prstGeom prst="rect">
              <a:avLst/>
            </a:prstGeom>
            <a:noFill/>
          </p:spPr>
          <p:txBody>
            <a:bodyPr wrap="none" lIns="90000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dirty="0"/>
                <a:t>*</a:t>
              </a:r>
              <a:r>
                <a:rPr lang="zh-CN" altLang="en-US" sz="1100" dirty="0"/>
                <a:t>*</a:t>
              </a:r>
              <a:r>
                <a:rPr lang="en-US" altLang="zh-CN" sz="1100" dirty="0"/>
                <a:t>*</a:t>
              </a:r>
              <a:endParaRPr lang="zh-CN" altLang="en-US" sz="1100" dirty="0"/>
            </a:p>
          </p:txBody>
        </p:sp>
        <p:sp>
          <p:nvSpPr>
            <p:cNvPr id="19" name="文本框 1">
              <a:extLst>
                <a:ext uri="{FF2B5EF4-FFF2-40B4-BE49-F238E27FC236}">
                  <a16:creationId xmlns:a16="http://schemas.microsoft.com/office/drawing/2014/main" id="{12D896D3-0831-4EA8-93BB-CED26E1A62B8}"/>
                </a:ext>
              </a:extLst>
            </p:cNvPr>
            <p:cNvSpPr txBox="1"/>
            <p:nvPr/>
          </p:nvSpPr>
          <p:spPr>
            <a:xfrm>
              <a:off x="8275665" y="395004"/>
              <a:ext cx="329007" cy="318582"/>
            </a:xfrm>
            <a:prstGeom prst="rect">
              <a:avLst/>
            </a:prstGeom>
            <a:noFill/>
          </p:spPr>
          <p:txBody>
            <a:bodyPr wrap="none" lIns="90000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dirty="0"/>
                <a:t>*</a:t>
              </a:r>
              <a:r>
                <a:rPr lang="zh-CN" altLang="en-US" sz="1100" dirty="0"/>
                <a:t>*</a:t>
              </a:r>
              <a:r>
                <a:rPr lang="en-US" altLang="zh-CN" sz="1100" dirty="0"/>
                <a:t>*</a:t>
              </a:r>
              <a:endParaRPr lang="zh-CN" altLang="en-US" sz="1100" dirty="0"/>
            </a:p>
          </p:txBody>
        </p:sp>
      </p:grp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13ADD7F9-A9CA-4AB0-BCE6-EE460B221E94}"/>
              </a:ext>
            </a:extLst>
          </p:cNvPr>
          <p:cNvGrpSpPr/>
          <p:nvPr/>
        </p:nvGrpSpPr>
        <p:grpSpPr>
          <a:xfrm>
            <a:off x="1511346" y="2862613"/>
            <a:ext cx="4362547" cy="1207181"/>
            <a:chOff x="5277258" y="2327572"/>
            <a:chExt cx="3600000" cy="1440000"/>
          </a:xfrm>
        </p:grpSpPr>
        <p:graphicFrame>
          <p:nvGraphicFramePr>
            <p:cNvPr id="21" name="图表 20">
              <a:extLst>
                <a:ext uri="{FF2B5EF4-FFF2-40B4-BE49-F238E27FC236}">
                  <a16:creationId xmlns:a16="http://schemas.microsoft.com/office/drawing/2014/main" id="{EA0185D8-8E64-4911-B1E8-984EA54D26D5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33614827"/>
                </p:ext>
              </p:extLst>
            </p:nvPr>
          </p:nvGraphicFramePr>
          <p:xfrm>
            <a:off x="5277258" y="2327572"/>
            <a:ext cx="3600000" cy="144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22" name="文本框 1">
              <a:extLst>
                <a:ext uri="{FF2B5EF4-FFF2-40B4-BE49-F238E27FC236}">
                  <a16:creationId xmlns:a16="http://schemas.microsoft.com/office/drawing/2014/main" id="{E455DF96-AD86-433B-B836-ABC23C4A4D6B}"/>
                </a:ext>
              </a:extLst>
            </p:cNvPr>
            <p:cNvSpPr txBox="1"/>
            <p:nvPr/>
          </p:nvSpPr>
          <p:spPr>
            <a:xfrm>
              <a:off x="5839444" y="3355005"/>
              <a:ext cx="329007" cy="312065"/>
            </a:xfrm>
            <a:prstGeom prst="rect">
              <a:avLst/>
            </a:prstGeom>
            <a:noFill/>
          </p:spPr>
          <p:txBody>
            <a:bodyPr wrap="none" lIns="90000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dirty="0"/>
                <a:t>*</a:t>
              </a:r>
              <a:r>
                <a:rPr lang="zh-CN" altLang="en-US" sz="1100" dirty="0"/>
                <a:t>*</a:t>
              </a:r>
              <a:r>
                <a:rPr lang="en-US" altLang="zh-CN" sz="1100" dirty="0"/>
                <a:t>*</a:t>
              </a:r>
              <a:endParaRPr lang="zh-CN" altLang="en-US" sz="1100" dirty="0"/>
            </a:p>
          </p:txBody>
        </p:sp>
        <p:sp>
          <p:nvSpPr>
            <p:cNvPr id="23" name="文本框 1">
              <a:extLst>
                <a:ext uri="{FF2B5EF4-FFF2-40B4-BE49-F238E27FC236}">
                  <a16:creationId xmlns:a16="http://schemas.microsoft.com/office/drawing/2014/main" id="{8984D42F-4BAB-4CEA-8EC6-E92A5143CFF1}"/>
                </a:ext>
              </a:extLst>
            </p:cNvPr>
            <p:cNvSpPr txBox="1"/>
            <p:nvPr/>
          </p:nvSpPr>
          <p:spPr>
            <a:xfrm>
              <a:off x="7414155" y="3298195"/>
              <a:ext cx="329007" cy="312065"/>
            </a:xfrm>
            <a:prstGeom prst="rect">
              <a:avLst/>
            </a:prstGeom>
            <a:noFill/>
          </p:spPr>
          <p:txBody>
            <a:bodyPr wrap="none" lIns="90000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dirty="0"/>
                <a:t>*</a:t>
              </a:r>
              <a:r>
                <a:rPr lang="zh-CN" altLang="en-US" sz="1100" dirty="0"/>
                <a:t>*</a:t>
              </a:r>
              <a:r>
                <a:rPr lang="en-US" altLang="zh-CN" sz="1100" dirty="0"/>
                <a:t>*</a:t>
              </a:r>
              <a:endParaRPr lang="zh-CN" altLang="en-US" sz="1100" dirty="0"/>
            </a:p>
          </p:txBody>
        </p:sp>
        <p:sp>
          <p:nvSpPr>
            <p:cNvPr id="24" name="文本框 1">
              <a:extLst>
                <a:ext uri="{FF2B5EF4-FFF2-40B4-BE49-F238E27FC236}">
                  <a16:creationId xmlns:a16="http://schemas.microsoft.com/office/drawing/2014/main" id="{A5CE20CE-99A7-4D43-9DB9-02B69E678502}"/>
                </a:ext>
              </a:extLst>
            </p:cNvPr>
            <p:cNvSpPr txBox="1"/>
            <p:nvPr/>
          </p:nvSpPr>
          <p:spPr>
            <a:xfrm>
              <a:off x="8197465" y="2545212"/>
              <a:ext cx="329007" cy="312065"/>
            </a:xfrm>
            <a:prstGeom prst="rect">
              <a:avLst/>
            </a:prstGeom>
            <a:noFill/>
          </p:spPr>
          <p:txBody>
            <a:bodyPr wrap="none" lIns="90000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/>
                <a:t>*</a:t>
              </a:r>
              <a:r>
                <a:rPr lang="zh-CN" altLang="en-US" sz="1100" b="1" dirty="0"/>
                <a:t>*</a:t>
              </a:r>
              <a:r>
                <a:rPr lang="en-US" altLang="zh-CN" sz="1100" b="1" dirty="0"/>
                <a:t>*</a:t>
              </a:r>
              <a:endParaRPr lang="zh-CN" altLang="en-US" sz="1100" b="1" dirty="0"/>
            </a:p>
          </p:txBody>
        </p:sp>
      </p:grpSp>
      <p:grpSp>
        <p:nvGrpSpPr>
          <p:cNvPr id="25" name="组合 24">
            <a:extLst>
              <a:ext uri="{FF2B5EF4-FFF2-40B4-BE49-F238E27FC236}">
                <a16:creationId xmlns:a16="http://schemas.microsoft.com/office/drawing/2014/main" id="{82020B56-D629-4C41-83DA-166EBDAC48B0}"/>
              </a:ext>
            </a:extLst>
          </p:cNvPr>
          <p:cNvGrpSpPr/>
          <p:nvPr/>
        </p:nvGrpSpPr>
        <p:grpSpPr>
          <a:xfrm>
            <a:off x="1455134" y="4238446"/>
            <a:ext cx="4320000" cy="1169730"/>
            <a:chOff x="5313502" y="4502735"/>
            <a:chExt cx="3600000" cy="1199977"/>
          </a:xfrm>
        </p:grpSpPr>
        <p:graphicFrame>
          <p:nvGraphicFramePr>
            <p:cNvPr id="26" name="图表 25">
              <a:extLst>
                <a:ext uri="{FF2B5EF4-FFF2-40B4-BE49-F238E27FC236}">
                  <a16:creationId xmlns:a16="http://schemas.microsoft.com/office/drawing/2014/main" id="{EB74DCEE-E03C-4DDA-B134-0F84BA1A028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23961354"/>
                </p:ext>
              </p:extLst>
            </p:nvPr>
          </p:nvGraphicFramePr>
          <p:xfrm>
            <a:off x="5313502" y="4502735"/>
            <a:ext cx="3600000" cy="119997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27" name="文本框 1">
              <a:extLst>
                <a:ext uri="{FF2B5EF4-FFF2-40B4-BE49-F238E27FC236}">
                  <a16:creationId xmlns:a16="http://schemas.microsoft.com/office/drawing/2014/main" id="{1FAF8E32-A21A-417E-9E6E-5FFF42F7B942}"/>
                </a:ext>
              </a:extLst>
            </p:cNvPr>
            <p:cNvSpPr txBox="1"/>
            <p:nvPr/>
          </p:nvSpPr>
          <p:spPr>
            <a:xfrm>
              <a:off x="5954938" y="4894564"/>
              <a:ext cx="270230" cy="335777"/>
            </a:xfrm>
            <a:prstGeom prst="rect">
              <a:avLst/>
            </a:prstGeom>
            <a:noFill/>
          </p:spPr>
          <p:txBody>
            <a:bodyPr wrap="none" lIns="90000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dirty="0"/>
                <a:t>**</a:t>
              </a:r>
              <a:endParaRPr lang="zh-CN" altLang="en-US" sz="1100" dirty="0"/>
            </a:p>
          </p:txBody>
        </p:sp>
        <p:sp>
          <p:nvSpPr>
            <p:cNvPr id="28" name="文本框 1">
              <a:extLst>
                <a:ext uri="{FF2B5EF4-FFF2-40B4-BE49-F238E27FC236}">
                  <a16:creationId xmlns:a16="http://schemas.microsoft.com/office/drawing/2014/main" id="{52704644-DDE1-41C1-AB44-8B4353DD8E26}"/>
                </a:ext>
              </a:extLst>
            </p:cNvPr>
            <p:cNvSpPr txBox="1"/>
            <p:nvPr/>
          </p:nvSpPr>
          <p:spPr>
            <a:xfrm>
              <a:off x="8308784" y="5147252"/>
              <a:ext cx="329007" cy="335777"/>
            </a:xfrm>
            <a:prstGeom prst="rect">
              <a:avLst/>
            </a:prstGeom>
            <a:noFill/>
          </p:spPr>
          <p:txBody>
            <a:bodyPr wrap="none" lIns="90000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dirty="0"/>
                <a:t>*</a:t>
              </a:r>
              <a:r>
                <a:rPr lang="zh-CN" altLang="en-US" sz="1100" dirty="0"/>
                <a:t>*</a:t>
              </a:r>
              <a:r>
                <a:rPr lang="en-US" altLang="zh-CN" sz="1100" dirty="0"/>
                <a:t>*</a:t>
              </a:r>
              <a:endParaRPr lang="zh-CN" altLang="en-US" sz="1100" dirty="0"/>
            </a:p>
          </p:txBody>
        </p:sp>
      </p:grpSp>
      <p:grpSp>
        <p:nvGrpSpPr>
          <p:cNvPr id="29" name="组合 28">
            <a:extLst>
              <a:ext uri="{FF2B5EF4-FFF2-40B4-BE49-F238E27FC236}">
                <a16:creationId xmlns:a16="http://schemas.microsoft.com/office/drawing/2014/main" id="{DF334D71-0163-414F-84BC-84078A330CA4}"/>
              </a:ext>
            </a:extLst>
          </p:cNvPr>
          <p:cNvGrpSpPr/>
          <p:nvPr/>
        </p:nvGrpSpPr>
        <p:grpSpPr>
          <a:xfrm>
            <a:off x="1367173" y="5438699"/>
            <a:ext cx="4320000" cy="1424587"/>
            <a:chOff x="522036" y="5133996"/>
            <a:chExt cx="3544040" cy="1648551"/>
          </a:xfrm>
        </p:grpSpPr>
        <p:graphicFrame>
          <p:nvGraphicFramePr>
            <p:cNvPr id="30" name="图表 29">
              <a:extLst>
                <a:ext uri="{FF2B5EF4-FFF2-40B4-BE49-F238E27FC236}">
                  <a16:creationId xmlns:a16="http://schemas.microsoft.com/office/drawing/2014/main" id="{1E68E201-267C-40AB-B7BC-913378F08F45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322287647"/>
                </p:ext>
              </p:extLst>
            </p:nvPr>
          </p:nvGraphicFramePr>
          <p:xfrm>
            <a:off x="522036" y="5133996"/>
            <a:ext cx="3544040" cy="164855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31" name="文本框 1">
              <a:extLst>
                <a:ext uri="{FF2B5EF4-FFF2-40B4-BE49-F238E27FC236}">
                  <a16:creationId xmlns:a16="http://schemas.microsoft.com/office/drawing/2014/main" id="{61D77E62-7A7E-4FDE-9880-2B07AD0B6E5B}"/>
                </a:ext>
              </a:extLst>
            </p:cNvPr>
            <p:cNvSpPr txBox="1"/>
            <p:nvPr/>
          </p:nvSpPr>
          <p:spPr>
            <a:xfrm>
              <a:off x="1951903" y="5211194"/>
              <a:ext cx="323892" cy="302739"/>
            </a:xfrm>
            <a:prstGeom prst="rect">
              <a:avLst/>
            </a:prstGeom>
            <a:noFill/>
          </p:spPr>
          <p:txBody>
            <a:bodyPr wrap="none" lIns="90000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/>
                <a:t>*</a:t>
              </a:r>
              <a:r>
                <a:rPr lang="zh-CN" altLang="en-US" sz="1100" b="1" dirty="0"/>
                <a:t>*</a:t>
              </a:r>
              <a:r>
                <a:rPr lang="en-US" altLang="zh-CN" sz="1100" b="1" dirty="0"/>
                <a:t>*</a:t>
              </a:r>
              <a:endParaRPr lang="zh-CN" altLang="en-US" sz="1100" b="1" dirty="0"/>
            </a:p>
          </p:txBody>
        </p:sp>
        <p:sp>
          <p:nvSpPr>
            <p:cNvPr id="32" name="文本框 1">
              <a:extLst>
                <a:ext uri="{FF2B5EF4-FFF2-40B4-BE49-F238E27FC236}">
                  <a16:creationId xmlns:a16="http://schemas.microsoft.com/office/drawing/2014/main" id="{3F004ACB-EDBD-40E2-82AD-2B0AAE82DE0E}"/>
                </a:ext>
              </a:extLst>
            </p:cNvPr>
            <p:cNvSpPr txBox="1"/>
            <p:nvPr/>
          </p:nvSpPr>
          <p:spPr>
            <a:xfrm>
              <a:off x="3303821" y="6168710"/>
              <a:ext cx="208166" cy="302739"/>
            </a:xfrm>
            <a:prstGeom prst="rect">
              <a:avLst/>
            </a:prstGeom>
            <a:noFill/>
          </p:spPr>
          <p:txBody>
            <a:bodyPr wrap="none" lIns="90000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dirty="0"/>
                <a:t>*</a:t>
              </a:r>
              <a:endParaRPr lang="zh-CN" altLang="en-US" sz="1100" dirty="0"/>
            </a:p>
          </p:txBody>
        </p:sp>
      </p:grpSp>
      <p:sp>
        <p:nvSpPr>
          <p:cNvPr id="36" name="矩形 35">
            <a:extLst>
              <a:ext uri="{FF2B5EF4-FFF2-40B4-BE49-F238E27FC236}">
                <a16:creationId xmlns:a16="http://schemas.microsoft.com/office/drawing/2014/main" id="{7D1BA2BF-71AE-42CA-B5C5-202FE1588309}"/>
              </a:ext>
            </a:extLst>
          </p:cNvPr>
          <p:cNvSpPr/>
          <p:nvPr/>
        </p:nvSpPr>
        <p:spPr>
          <a:xfrm>
            <a:off x="1251493" y="1582919"/>
            <a:ext cx="227100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zh-CN" sz="1400" i="1" kern="100" dirty="0">
                <a:solidFill>
                  <a:schemeClr val="bg2">
                    <a:lumMod val="50000"/>
                  </a:schemeClr>
                </a:solidFill>
                <a:latin typeface="等线" panose="02010600030101010101" pitchFamily="2" charset="-122"/>
                <a:cs typeface="Times New Roman" panose="02020603050405020304" pitchFamily="18" charset="0"/>
              </a:rPr>
              <a:t>SlSWEET10b</a:t>
            </a:r>
            <a:endParaRPr lang="en-US" altLang="zh-CN" sz="1200" i="1" kern="100" dirty="0">
              <a:solidFill>
                <a:schemeClr val="bg2">
                  <a:lumMod val="50000"/>
                </a:schemeClr>
              </a:solidFill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7" name="矩形 36">
            <a:extLst>
              <a:ext uri="{FF2B5EF4-FFF2-40B4-BE49-F238E27FC236}">
                <a16:creationId xmlns:a16="http://schemas.microsoft.com/office/drawing/2014/main" id="{01056F47-96FF-4248-905F-6DDDB3494BED}"/>
              </a:ext>
            </a:extLst>
          </p:cNvPr>
          <p:cNvSpPr/>
          <p:nvPr/>
        </p:nvSpPr>
        <p:spPr>
          <a:xfrm>
            <a:off x="1255248" y="2852167"/>
            <a:ext cx="227100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zh-CN" sz="1400" i="1" kern="100" dirty="0">
                <a:solidFill>
                  <a:schemeClr val="bg2">
                    <a:lumMod val="50000"/>
                  </a:schemeClr>
                </a:solidFill>
                <a:latin typeface="等线" panose="02010600030101010101" pitchFamily="2" charset="-122"/>
                <a:cs typeface="Times New Roman" panose="02020603050405020304" pitchFamily="18" charset="0"/>
              </a:rPr>
              <a:t>SlSWEET11a</a:t>
            </a:r>
            <a:endParaRPr lang="en-US" altLang="zh-CN" sz="1200" kern="100" dirty="0">
              <a:solidFill>
                <a:schemeClr val="bg2">
                  <a:lumMod val="50000"/>
                </a:schemeClr>
              </a:solidFill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8" name="矩形 37">
            <a:extLst>
              <a:ext uri="{FF2B5EF4-FFF2-40B4-BE49-F238E27FC236}">
                <a16:creationId xmlns:a16="http://schemas.microsoft.com/office/drawing/2014/main" id="{0752352D-E050-41ED-B687-C2722EF4C63B}"/>
              </a:ext>
            </a:extLst>
          </p:cNvPr>
          <p:cNvSpPr/>
          <p:nvPr/>
        </p:nvSpPr>
        <p:spPr>
          <a:xfrm>
            <a:off x="1251493" y="4135692"/>
            <a:ext cx="227100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zh-CN" sz="1400" i="1" kern="100" dirty="0">
                <a:solidFill>
                  <a:schemeClr val="bg2">
                    <a:lumMod val="50000"/>
                  </a:schemeClr>
                </a:solidFill>
                <a:latin typeface="等线" panose="02010600030101010101" pitchFamily="2" charset="-122"/>
                <a:cs typeface="Times New Roman" panose="02020603050405020304" pitchFamily="18" charset="0"/>
              </a:rPr>
              <a:t>SlSWEET12a</a:t>
            </a:r>
            <a:endParaRPr lang="en-US" altLang="zh-CN" sz="1200" kern="100" dirty="0">
              <a:solidFill>
                <a:schemeClr val="bg2">
                  <a:lumMod val="50000"/>
                </a:schemeClr>
              </a:solidFill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9" name="矩形 38">
            <a:extLst>
              <a:ext uri="{FF2B5EF4-FFF2-40B4-BE49-F238E27FC236}">
                <a16:creationId xmlns:a16="http://schemas.microsoft.com/office/drawing/2014/main" id="{48D048F7-56F3-4B2E-BDA6-385409EA6B03}"/>
              </a:ext>
            </a:extLst>
          </p:cNvPr>
          <p:cNvSpPr/>
          <p:nvPr/>
        </p:nvSpPr>
        <p:spPr>
          <a:xfrm>
            <a:off x="1197896" y="5400467"/>
            <a:ext cx="227100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zh-CN" sz="1400" i="1" kern="100" dirty="0">
                <a:solidFill>
                  <a:schemeClr val="bg2">
                    <a:lumMod val="50000"/>
                  </a:schemeClr>
                </a:solidFill>
                <a:latin typeface="等线" panose="02010600030101010101" pitchFamily="2" charset="-122"/>
                <a:cs typeface="Times New Roman" panose="02020603050405020304" pitchFamily="18" charset="0"/>
              </a:rPr>
              <a:t>SlSWEET16</a:t>
            </a:r>
            <a:endParaRPr lang="en-US" altLang="zh-CN" sz="1200" kern="100" dirty="0">
              <a:solidFill>
                <a:schemeClr val="bg2">
                  <a:lumMod val="50000"/>
                </a:schemeClr>
              </a:solidFill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0" name="矩形 39">
            <a:extLst>
              <a:ext uri="{FF2B5EF4-FFF2-40B4-BE49-F238E27FC236}">
                <a16:creationId xmlns:a16="http://schemas.microsoft.com/office/drawing/2014/main" id="{09449467-54E9-4E6C-B3E3-BF370B7EE540}"/>
              </a:ext>
            </a:extLst>
          </p:cNvPr>
          <p:cNvSpPr/>
          <p:nvPr/>
        </p:nvSpPr>
        <p:spPr>
          <a:xfrm>
            <a:off x="1219763" y="96552"/>
            <a:ext cx="227100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zh-CN" sz="1400" i="1" kern="100" dirty="0">
                <a:solidFill>
                  <a:schemeClr val="bg2">
                    <a:lumMod val="50000"/>
                  </a:schemeClr>
                </a:solidFill>
                <a:latin typeface="等线" panose="02010600030101010101" pitchFamily="2" charset="-122"/>
                <a:cs typeface="Times New Roman" panose="02020603050405020304" pitchFamily="18" charset="0"/>
              </a:rPr>
              <a:t>SlSWEET5b</a:t>
            </a:r>
          </a:p>
        </p:txBody>
      </p:sp>
      <p:sp>
        <p:nvSpPr>
          <p:cNvPr id="33" name="文本框 6">
            <a:extLst>
              <a:ext uri="{FF2B5EF4-FFF2-40B4-BE49-F238E27FC236}">
                <a16:creationId xmlns:a16="http://schemas.microsoft.com/office/drawing/2014/main" id="{4846FC22-F705-4EBE-863F-C1D89A867983}"/>
              </a:ext>
            </a:extLst>
          </p:cNvPr>
          <p:cNvSpPr txBox="1"/>
          <p:nvPr/>
        </p:nvSpPr>
        <p:spPr>
          <a:xfrm>
            <a:off x="742014" y="6893809"/>
            <a:ext cx="590121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3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expression of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WEET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ansporter genes,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lSWEET5b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0b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a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2a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6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sterisks indicate significant differences (Student’s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-test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*, p&lt;0.05; **, p&lt;0.01; ***, p&lt;0.001, n=4) between 2DBA and 4DAA.</a:t>
            </a:r>
          </a:p>
        </p:txBody>
      </p:sp>
    </p:spTree>
    <p:extLst>
      <p:ext uri="{BB962C8B-B14F-4D97-AF65-F5344CB8AC3E}">
        <p14:creationId xmlns:p14="http://schemas.microsoft.com/office/powerpoint/2010/main" val="2995674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768</TotalTime>
  <Words>235</Words>
  <Application>Microsoft Office PowerPoint</Application>
  <PresentationFormat>A4 纸张(210x297 毫米)</PresentationFormat>
  <Paragraphs>41</Paragraphs>
  <Slides>3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0" baseType="lpstr">
      <vt:lpstr>等线</vt:lpstr>
      <vt:lpstr>等线 Light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i Shen</dc:creator>
  <cp:lastModifiedBy>申 思</cp:lastModifiedBy>
  <cp:revision>261</cp:revision>
  <dcterms:created xsi:type="dcterms:W3CDTF">2017-11-29T04:06:40Z</dcterms:created>
  <dcterms:modified xsi:type="dcterms:W3CDTF">2019-03-02T15:44:11Z</dcterms:modified>
</cp:coreProperties>
</file>